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912725" cy="10980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69991C-9789-43E4-BED0-0659299C4FE5}" v="3" dt="2023-12-27T01:56:31.073"/>
    <p1510:client id="{434244B1-39FF-4ED9-AA24-4ACBC79A9C1F}" v="2" dt="2023-12-27T02:13:58.983"/>
    <p1510:client id="{556D9532-AB72-4C71-8BFA-BF2B17A0CB6C}" v="32" dt="2023-12-27T01:16:52.5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13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woong Kim" userId="c6581f603476f281" providerId="LiveId" clId="{556D9532-AB72-4C71-8BFA-BF2B17A0CB6C}"/>
    <pc:docChg chg="undo custSel modSld">
      <pc:chgData name="Kyuwoong Kim" userId="c6581f603476f281" providerId="LiveId" clId="{556D9532-AB72-4C71-8BFA-BF2B17A0CB6C}" dt="2023-12-27T01:20:43.701" v="706" actId="1076"/>
      <pc:docMkLst>
        <pc:docMk/>
      </pc:docMkLst>
      <pc:sldChg chg="addSp delSp modSp mod">
        <pc:chgData name="Kyuwoong Kim" userId="c6581f603476f281" providerId="LiveId" clId="{556D9532-AB72-4C71-8BFA-BF2B17A0CB6C}" dt="2023-12-27T01:20:43.701" v="706" actId="1076"/>
        <pc:sldMkLst>
          <pc:docMk/>
          <pc:sldMk cId="648833912" sldId="256"/>
        </pc:sldMkLst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2" creationId="{FD3CC9AA-26FA-3AD2-5616-B24CBD74D53A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" creationId="{980E1B1C-5782-65BA-EB03-E4005B456A6F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4" creationId="{1C6B68EC-F57B-C1A5-8B87-27D3DE0EA4F8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" creationId="{027AA216-DF50-0D66-EF32-BD54A8AA60B5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5" creationId="{FAEA2DB1-F50B-F0A4-D080-98E28C6F2E60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8" creationId="{97DD32AB-1146-40EB-3909-3D199FAB0E30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8" creationId="{D553A7A6-7D68-32A5-7273-A9A66CE3502C}"/>
          </ac:spMkLst>
        </pc:spChg>
        <pc:spChg chg="add del mod">
          <ac:chgData name="Kyuwoong Kim" userId="c6581f603476f281" providerId="LiveId" clId="{556D9532-AB72-4C71-8BFA-BF2B17A0CB6C}" dt="2023-12-26T23:57:21.815" v="107" actId="478"/>
          <ac:spMkLst>
            <pc:docMk/>
            <pc:sldMk cId="648833912" sldId="256"/>
            <ac:spMk id="9" creationId="{2F06267E-7068-D8B5-5C35-23FCF430FD94}"/>
          </ac:spMkLst>
        </pc:spChg>
        <pc:spChg chg="add mod">
          <ac:chgData name="Kyuwoong Kim" userId="c6581f603476f281" providerId="LiveId" clId="{556D9532-AB72-4C71-8BFA-BF2B17A0CB6C}" dt="2023-12-27T01:17:04.857" v="700" actId="1076"/>
          <ac:spMkLst>
            <pc:docMk/>
            <pc:sldMk cId="648833912" sldId="256"/>
            <ac:spMk id="9" creationId="{C38CFEB1-5D97-15BA-1BB8-A579D9511F5B}"/>
          </ac:spMkLst>
        </pc:spChg>
        <pc:spChg chg="add del mod">
          <ac:chgData name="Kyuwoong Kim" userId="c6581f603476f281" providerId="LiveId" clId="{556D9532-AB72-4C71-8BFA-BF2B17A0CB6C}" dt="2023-12-26T23:57:23.084" v="109" actId="478"/>
          <ac:spMkLst>
            <pc:docMk/>
            <pc:sldMk cId="648833912" sldId="256"/>
            <ac:spMk id="10" creationId="{4C6F889B-B24B-64AE-60D6-F8504A016DC7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1" creationId="{1B1DC1A3-A19A-5EB6-CBBB-A2FE1234B35D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1" creationId="{94EFB512-D4E6-2BFA-E7B7-A4AF376B498D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2" creationId="{251F90EA-C15F-4776-7BAD-D7CA740247A4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2" creationId="{7E9BFFAB-13B8-AF42-8201-87FBFDA58E42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3" creationId="{CBA48424-BA70-4B9A-9D1F-825934D0432C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3" creationId="{D471E572-B0C6-999F-59C2-61AD127B40F1}"/>
          </ac:spMkLst>
        </pc:spChg>
        <pc:spChg chg="add del mod">
          <ac:chgData name="Kyuwoong Kim" userId="c6581f603476f281" providerId="LiveId" clId="{556D9532-AB72-4C71-8BFA-BF2B17A0CB6C}" dt="2023-12-26T23:57:24.975" v="110" actId="478"/>
          <ac:spMkLst>
            <pc:docMk/>
            <pc:sldMk cId="648833912" sldId="256"/>
            <ac:spMk id="14" creationId="{31D11B23-DDDD-EDFB-BF7B-B9F9289880DC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5" creationId="{832C9E58-ED44-A228-42DE-08C68783B30B}"/>
          </ac:spMkLst>
        </pc:spChg>
        <pc:spChg chg="add mod">
          <ac:chgData name="Kyuwoong Kim" userId="c6581f603476f281" providerId="LiveId" clId="{556D9532-AB72-4C71-8BFA-BF2B17A0CB6C}" dt="2023-12-27T01:20:19.206" v="701" actId="1076"/>
          <ac:spMkLst>
            <pc:docMk/>
            <pc:sldMk cId="648833912" sldId="256"/>
            <ac:spMk id="16" creationId="{A115F86F-7F57-9521-2997-8B0366BA61C1}"/>
          </ac:spMkLst>
        </pc:spChg>
        <pc:spChg chg="add del mod">
          <ac:chgData name="Kyuwoong Kim" userId="c6581f603476f281" providerId="LiveId" clId="{556D9532-AB72-4C71-8BFA-BF2B17A0CB6C}" dt="2023-12-26T23:57:16.139" v="104" actId="478"/>
          <ac:spMkLst>
            <pc:docMk/>
            <pc:sldMk cId="648833912" sldId="256"/>
            <ac:spMk id="17" creationId="{C522D15C-F787-CC4F-FEB7-EA919E17892D}"/>
          </ac:spMkLst>
        </pc:spChg>
        <pc:spChg chg="add mod">
          <ac:chgData name="Kyuwoong Kim" userId="c6581f603476f281" providerId="LiveId" clId="{556D9532-AB72-4C71-8BFA-BF2B17A0CB6C}" dt="2023-12-27T01:20:35.837" v="704" actId="1076"/>
          <ac:spMkLst>
            <pc:docMk/>
            <pc:sldMk cId="648833912" sldId="256"/>
            <ac:spMk id="18" creationId="{2C7B121F-3BEF-3CE1-756F-B8BCEA464733}"/>
          </ac:spMkLst>
        </pc:spChg>
        <pc:spChg chg="add mod">
          <ac:chgData name="Kyuwoong Kim" userId="c6581f603476f281" providerId="LiveId" clId="{556D9532-AB72-4C71-8BFA-BF2B17A0CB6C}" dt="2023-12-27T01:20:28.409" v="703" actId="1076"/>
          <ac:spMkLst>
            <pc:docMk/>
            <pc:sldMk cId="648833912" sldId="256"/>
            <ac:spMk id="19" creationId="{C19EFB19-09EC-89F1-A1C2-F48AD3F1B295}"/>
          </ac:spMkLst>
        </pc:spChg>
        <pc:spChg chg="add del mod">
          <ac:chgData name="Kyuwoong Kim" userId="c6581f603476f281" providerId="LiveId" clId="{556D9532-AB72-4C71-8BFA-BF2B17A0CB6C}" dt="2023-12-26T23:57:34.541" v="118" actId="478"/>
          <ac:spMkLst>
            <pc:docMk/>
            <pc:sldMk cId="648833912" sldId="256"/>
            <ac:spMk id="20" creationId="{45E8F04C-DB45-ABA6-7AEC-4929D729083E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21" creationId="{52B25AC5-F550-547A-7C3C-5CC42318BBBC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21" creationId="{62658A79-ED74-6FAE-981C-E7DE6217D7C6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22" creationId="{C7838085-C0D9-C2EF-2121-E2058AF99563}"/>
          </ac:spMkLst>
        </pc:spChg>
        <pc:spChg chg="add mod">
          <ac:chgData name="Kyuwoong Kim" userId="c6581f603476f281" providerId="LiveId" clId="{556D9532-AB72-4C71-8BFA-BF2B17A0CB6C}" dt="2023-12-27T01:20:43.701" v="706" actId="1076"/>
          <ac:spMkLst>
            <pc:docMk/>
            <pc:sldMk cId="648833912" sldId="256"/>
            <ac:spMk id="22" creationId="{F38EBE54-0362-C1B9-13EE-13306B3E6B30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3" creationId="{8E53A1CF-FE7C-1C53-CA6B-D110B5B0CF6C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4" creationId="{87BEB7EB-53A9-6261-6205-F559A8E8254B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25" creationId="{7E968179-7680-E8FA-AAF3-46B859076AE8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8" creationId="{6CC523FB-2017-9330-E464-B51CED8C8523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9" creationId="{84D997AF-10C2-7BCE-7E4B-900B41D3F831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30" creationId="{4335569D-7366-F6A9-F34B-05B3CA2358D7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31" creationId="{3E544B73-14FB-8C0A-54BB-F1BA0C604724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2" creationId="{4678528B-DB09-94AB-B587-41D5198D9A26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3" creationId="{61971DD9-EE9D-3C64-F8DD-8183D3D3456F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4" creationId="{80FA53D5-FEE6-02E5-6DE0-C9E26F2331AB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5" creationId="{3B5806F3-36F5-6DF5-0AF2-60DF275BB797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36" creationId="{B7EEE248-8304-9643-3D5B-3A97CA501CAE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37" creationId="{5179028C-B7AA-2FD1-3382-46A04DAF1845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8" creationId="{549A40D2-B161-41AC-AD42-9BBE11DBEF59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9" creationId="{0C2D4290-83CA-546A-268C-60FFDCA6B305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40" creationId="{90309B63-1CFE-2EFE-B9B5-8D7A365C6ACC}"/>
          </ac:spMkLst>
        </pc:spChg>
        <pc:spChg chg="add del mod">
          <ac:chgData name="Kyuwoong Kim" userId="c6581f603476f281" providerId="LiveId" clId="{556D9532-AB72-4C71-8BFA-BF2B17A0CB6C}" dt="2023-12-26T23:58:03.399" v="134" actId="478"/>
          <ac:spMkLst>
            <pc:docMk/>
            <pc:sldMk cId="648833912" sldId="256"/>
            <ac:spMk id="45" creationId="{957CFF35-5125-7D58-0D8E-6070F60F535E}"/>
          </ac:spMkLst>
        </pc:spChg>
        <pc:spChg chg="add del mod">
          <ac:chgData name="Kyuwoong Kim" userId="c6581f603476f281" providerId="LiveId" clId="{556D9532-AB72-4C71-8BFA-BF2B17A0CB6C}" dt="2023-12-26T23:58:04.714" v="135" actId="478"/>
          <ac:spMkLst>
            <pc:docMk/>
            <pc:sldMk cId="648833912" sldId="256"/>
            <ac:spMk id="46" creationId="{2EB034BA-3C50-8095-3123-0326342D765B}"/>
          </ac:spMkLst>
        </pc:spChg>
        <pc:spChg chg="add del mod">
          <ac:chgData name="Kyuwoong Kim" userId="c6581f603476f281" providerId="LiveId" clId="{556D9532-AB72-4C71-8BFA-BF2B17A0CB6C}" dt="2023-12-26T23:58:08.060" v="137" actId="478"/>
          <ac:spMkLst>
            <pc:docMk/>
            <pc:sldMk cId="648833912" sldId="256"/>
            <ac:spMk id="47" creationId="{9B69C710-DE2D-1BAC-FADB-7DA4A024CE07}"/>
          </ac:spMkLst>
        </pc:spChg>
        <pc:spChg chg="add del mod">
          <ac:chgData name="Kyuwoong Kim" userId="c6581f603476f281" providerId="LiveId" clId="{556D9532-AB72-4C71-8BFA-BF2B17A0CB6C}" dt="2023-12-26T23:58:01.112" v="133" actId="478"/>
          <ac:spMkLst>
            <pc:docMk/>
            <pc:sldMk cId="648833912" sldId="256"/>
            <ac:spMk id="48" creationId="{67E3E48D-6F27-34D7-2844-6629C41D4F8F}"/>
          </ac:spMkLst>
        </pc:spChg>
        <pc:spChg chg="add del mod">
          <ac:chgData name="Kyuwoong Kim" userId="c6581f603476f281" providerId="LiveId" clId="{556D9532-AB72-4C71-8BFA-BF2B17A0CB6C}" dt="2023-12-26T23:58:06.046" v="136" actId="478"/>
          <ac:spMkLst>
            <pc:docMk/>
            <pc:sldMk cId="648833912" sldId="256"/>
            <ac:spMk id="49" creationId="{E07270A3-BCC4-7098-3E10-099F1DD8C4D1}"/>
          </ac:spMkLst>
        </pc:spChg>
        <pc:spChg chg="add del mod">
          <ac:chgData name="Kyuwoong Kim" userId="c6581f603476f281" providerId="LiveId" clId="{556D9532-AB72-4C71-8BFA-BF2B17A0CB6C}" dt="2023-12-26T23:58:09.037" v="138" actId="478"/>
          <ac:spMkLst>
            <pc:docMk/>
            <pc:sldMk cId="648833912" sldId="256"/>
            <ac:spMk id="50" creationId="{3AE3F4EE-4D07-FA75-7451-4BA19A6D12E7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1" creationId="{958350B1-BEF6-2452-8208-F4A3A8ED5EA4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2" creationId="{AF566DC3-DBE2-50A7-D072-B6DF87688FC9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3" creationId="{6D8DAF6A-D9D3-46E5-D0A4-12BAAAF7245E}"/>
          </ac:spMkLst>
        </pc:spChg>
        <pc:grpChg chg="del">
          <ac:chgData name="Kyuwoong Kim" userId="c6581f603476f281" providerId="LiveId" clId="{556D9532-AB72-4C71-8BFA-BF2B17A0CB6C}" dt="2023-12-26T23:53:55.444" v="5" actId="478"/>
          <ac:grpSpMkLst>
            <pc:docMk/>
            <pc:sldMk cId="648833912" sldId="256"/>
            <ac:grpSpMk id="16" creationId="{DF6075C8-D9A8-1BA5-6729-88B15C885B2D}"/>
          </ac:grpSpMkLst>
        </pc:grp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2" creationId="{A7E0DEB9-D172-D4CE-9CC1-F9C55B63D1A8}"/>
          </ac:picMkLst>
        </pc:pic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3" creationId="{A0A6CB00-12F0-B4E9-88A2-B06026F9DA91}"/>
          </ac:picMkLst>
        </pc:pic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4" creationId="{F3923BCE-31B9-CA0F-397E-B63633BEBADB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6" creationId="{2E0E3B99-2D8A-1654-1D9E-E8E5DC6EE455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7" creationId="{6EC75941-0253-1363-18C9-092E3CF758D1}"/>
          </ac:picMkLst>
        </pc:picChg>
        <pc:picChg chg="del">
          <ac:chgData name="Kyuwoong Kim" userId="c6581f603476f281" providerId="LiveId" clId="{556D9532-AB72-4C71-8BFA-BF2B17A0CB6C}" dt="2023-12-26T23:53:48.624" v="0" actId="478"/>
          <ac:picMkLst>
            <pc:docMk/>
            <pc:sldMk cId="648833912" sldId="256"/>
            <ac:picMk id="15" creationId="{23B2810A-7602-6CA4-4CB2-C591CF3DA2A5}"/>
          </ac:picMkLst>
        </pc:picChg>
        <pc:picChg chg="del">
          <ac:chgData name="Kyuwoong Kim" userId="c6581f603476f281" providerId="LiveId" clId="{556D9532-AB72-4C71-8BFA-BF2B17A0CB6C}" dt="2023-12-26T23:53:48.974" v="1" actId="478"/>
          <ac:picMkLst>
            <pc:docMk/>
            <pc:sldMk cId="648833912" sldId="256"/>
            <ac:picMk id="26" creationId="{07FCE925-4484-CCCE-19AD-B78566DC0BC1}"/>
          </ac:picMkLst>
        </pc:picChg>
        <pc:picChg chg="del">
          <ac:chgData name="Kyuwoong Kim" userId="c6581f603476f281" providerId="LiveId" clId="{556D9532-AB72-4C71-8BFA-BF2B17A0CB6C}" dt="2023-12-26T23:53:49.350" v="2" actId="478"/>
          <ac:picMkLst>
            <pc:docMk/>
            <pc:sldMk cId="648833912" sldId="256"/>
            <ac:picMk id="27" creationId="{250591F6-C4B2-33FA-F314-E5035DD94202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41" creationId="{5A214A41-6125-1A42-AE2D-79CB4584ECFD}"/>
          </ac:picMkLst>
        </pc:picChg>
        <pc:picChg chg="add mod">
          <ac:chgData name="Kyuwoong Kim" userId="c6581f603476f281" providerId="LiveId" clId="{556D9532-AB72-4C71-8BFA-BF2B17A0CB6C}" dt="2023-12-27T01:20:39.958" v="705" actId="14100"/>
          <ac:picMkLst>
            <pc:docMk/>
            <pc:sldMk cId="648833912" sldId="256"/>
            <ac:picMk id="42" creationId="{6F25A9B9-D76D-3E46-25B7-79D914A658F2}"/>
          </ac:picMkLst>
        </pc:picChg>
        <pc:picChg chg="add mod">
          <ac:chgData name="Kyuwoong Kim" userId="c6581f603476f281" providerId="LiveId" clId="{556D9532-AB72-4C71-8BFA-BF2B17A0CB6C}" dt="2023-12-27T01:20:22.527" v="702" actId="14100"/>
          <ac:picMkLst>
            <pc:docMk/>
            <pc:sldMk cId="648833912" sldId="256"/>
            <ac:picMk id="43" creationId="{AF8077C5-FE9A-A0AF-1A5A-CD3D3B7AE75E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44" creationId="{3D3F847B-2BE8-9E25-E12D-17BCDF229CB5}"/>
          </ac:picMkLst>
        </pc:picChg>
      </pc:sldChg>
    </pc:docChg>
  </pc:docChgLst>
  <pc:docChgLst>
    <pc:chgData name="Kyuwoong Kim" userId="c6581f603476f281" providerId="LiveId" clId="{434244B1-39FF-4ED9-AA24-4ACBC79A9C1F}"/>
    <pc:docChg chg="undo custSel modSld">
      <pc:chgData name="Kyuwoong Kim" userId="c6581f603476f281" providerId="LiveId" clId="{434244B1-39FF-4ED9-AA24-4ACBC79A9C1F}" dt="2023-12-27T04:49:51.143" v="134" actId="20577"/>
      <pc:docMkLst>
        <pc:docMk/>
      </pc:docMkLst>
      <pc:sldChg chg="addSp delSp modSp mod">
        <pc:chgData name="Kyuwoong Kim" userId="c6581f603476f281" providerId="LiveId" clId="{434244B1-39FF-4ED9-AA24-4ACBC79A9C1F}" dt="2023-12-27T04:49:51.143" v="134" actId="20577"/>
        <pc:sldMkLst>
          <pc:docMk/>
          <pc:sldMk cId="648833912" sldId="256"/>
        </pc:sldMkLst>
        <pc:spChg chg="mod">
          <ac:chgData name="Kyuwoong Kim" userId="c6581f603476f281" providerId="LiveId" clId="{434244B1-39FF-4ED9-AA24-4ACBC79A9C1F}" dt="2023-12-27T02:14:48.398" v="111" actId="1076"/>
          <ac:spMkLst>
            <pc:docMk/>
            <pc:sldMk cId="648833912" sldId="256"/>
            <ac:spMk id="5" creationId="{027AA216-DF50-0D66-EF32-BD54A8AA60B5}"/>
          </ac:spMkLst>
        </pc:spChg>
        <pc:spChg chg="mod">
          <ac:chgData name="Kyuwoong Kim" userId="c6581f603476f281" providerId="LiveId" clId="{434244B1-39FF-4ED9-AA24-4ACBC79A9C1F}" dt="2023-12-27T04:49:51.143" v="134" actId="20577"/>
          <ac:spMkLst>
            <pc:docMk/>
            <pc:sldMk cId="648833912" sldId="256"/>
            <ac:spMk id="9" creationId="{C38CFEB1-5D97-15BA-1BB8-A579D9511F5B}"/>
          </ac:spMkLst>
        </pc:spChg>
        <pc:spChg chg="mod">
          <ac:chgData name="Kyuwoong Kim" userId="c6581f603476f281" providerId="LiveId" clId="{434244B1-39FF-4ED9-AA24-4ACBC79A9C1F}" dt="2023-12-27T02:14:50.733" v="112" actId="1076"/>
          <ac:spMkLst>
            <pc:docMk/>
            <pc:sldMk cId="648833912" sldId="256"/>
            <ac:spMk id="11" creationId="{94EFB512-D4E6-2BFA-E7B7-A4AF376B498D}"/>
          </ac:spMkLst>
        </pc:spChg>
        <pc:spChg chg="mod">
          <ac:chgData name="Kyuwoong Kim" userId="c6581f603476f281" providerId="LiveId" clId="{434244B1-39FF-4ED9-AA24-4ACBC79A9C1F}" dt="2023-12-27T02:15:32.885" v="124" actId="1076"/>
          <ac:spMkLst>
            <pc:docMk/>
            <pc:sldMk cId="648833912" sldId="256"/>
            <ac:spMk id="16" creationId="{A115F86F-7F57-9521-2997-8B0366BA61C1}"/>
          </ac:spMkLst>
        </pc:spChg>
        <pc:spChg chg="mod">
          <ac:chgData name="Kyuwoong Kim" userId="c6581f603476f281" providerId="LiveId" clId="{434244B1-39FF-4ED9-AA24-4ACBC79A9C1F}" dt="2023-12-27T02:15:38.500" v="125" actId="1076"/>
          <ac:spMkLst>
            <pc:docMk/>
            <pc:sldMk cId="648833912" sldId="256"/>
            <ac:spMk id="19" creationId="{C19EFB19-09EC-89F1-A1C2-F48AD3F1B295}"/>
          </ac:spMkLst>
        </pc:spChg>
        <pc:spChg chg="mod">
          <ac:chgData name="Kyuwoong Kim" userId="c6581f603476f281" providerId="LiveId" clId="{434244B1-39FF-4ED9-AA24-4ACBC79A9C1F}" dt="2023-12-27T02:15:53.477" v="129" actId="1076"/>
          <ac:spMkLst>
            <pc:docMk/>
            <pc:sldMk cId="648833912" sldId="256"/>
            <ac:spMk id="21" creationId="{52B25AC5-F550-547A-7C3C-5CC42318BBBC}"/>
          </ac:spMkLst>
        </pc:spChg>
        <pc:spChg chg="mod">
          <ac:chgData name="Kyuwoong Kim" userId="c6581f603476f281" providerId="LiveId" clId="{434244B1-39FF-4ED9-AA24-4ACBC79A9C1F}" dt="2023-12-27T02:15:57.508" v="130" actId="1076"/>
          <ac:spMkLst>
            <pc:docMk/>
            <pc:sldMk cId="648833912" sldId="256"/>
            <ac:spMk id="22" creationId="{F38EBE54-0362-C1B9-13EE-13306B3E6B30}"/>
          </ac:spMkLst>
        </pc:spChg>
        <pc:spChg chg="mod">
          <ac:chgData name="Kyuwoong Kim" userId="c6581f603476f281" providerId="LiveId" clId="{434244B1-39FF-4ED9-AA24-4ACBC79A9C1F}" dt="2023-12-27T02:11:59.266" v="17" actId="20577"/>
          <ac:spMkLst>
            <pc:docMk/>
            <pc:sldMk cId="648833912" sldId="256"/>
            <ac:spMk id="38" creationId="{549A40D2-B161-41AC-AD42-9BBE11DBEF59}"/>
          </ac:spMkLst>
        </pc:spChg>
        <pc:spChg chg="mod">
          <ac:chgData name="Kyuwoong Kim" userId="c6581f603476f281" providerId="LiveId" clId="{434244B1-39FF-4ED9-AA24-4ACBC79A9C1F}" dt="2023-12-27T02:12:19.684" v="34" actId="20577"/>
          <ac:spMkLst>
            <pc:docMk/>
            <pc:sldMk cId="648833912" sldId="256"/>
            <ac:spMk id="39" creationId="{0C2D4290-83CA-546A-268C-60FFDCA6B305}"/>
          </ac:spMkLst>
        </pc:spChg>
        <pc:spChg chg="mod">
          <ac:chgData name="Kyuwoong Kim" userId="c6581f603476f281" providerId="LiveId" clId="{434244B1-39FF-4ED9-AA24-4ACBC79A9C1F}" dt="2023-12-27T02:12:38.252" v="45" actId="20577"/>
          <ac:spMkLst>
            <pc:docMk/>
            <pc:sldMk cId="648833912" sldId="256"/>
            <ac:spMk id="40" creationId="{90309B63-1CFE-2EFE-B9B5-8D7A365C6ACC}"/>
          </ac:spMkLst>
        </pc:spChg>
        <pc:spChg chg="mod">
          <ac:chgData name="Kyuwoong Kim" userId="c6581f603476f281" providerId="LiveId" clId="{434244B1-39FF-4ED9-AA24-4ACBC79A9C1F}" dt="2023-12-27T02:13:17.267" v="65" actId="20577"/>
          <ac:spMkLst>
            <pc:docMk/>
            <pc:sldMk cId="648833912" sldId="256"/>
            <ac:spMk id="51" creationId="{958350B1-BEF6-2452-8208-F4A3A8ED5EA4}"/>
          </ac:spMkLst>
        </pc:spChg>
        <pc:spChg chg="mod">
          <ac:chgData name="Kyuwoong Kim" userId="c6581f603476f281" providerId="LiveId" clId="{434244B1-39FF-4ED9-AA24-4ACBC79A9C1F}" dt="2023-12-27T02:13:32.268" v="81" actId="20577"/>
          <ac:spMkLst>
            <pc:docMk/>
            <pc:sldMk cId="648833912" sldId="256"/>
            <ac:spMk id="52" creationId="{AF566DC3-DBE2-50A7-D072-B6DF87688FC9}"/>
          </ac:spMkLst>
        </pc:spChg>
        <pc:spChg chg="mod">
          <ac:chgData name="Kyuwoong Kim" userId="c6581f603476f281" providerId="LiveId" clId="{434244B1-39FF-4ED9-AA24-4ACBC79A9C1F}" dt="2023-12-27T02:13:50.675" v="97" actId="20577"/>
          <ac:spMkLst>
            <pc:docMk/>
            <pc:sldMk cId="648833912" sldId="256"/>
            <ac:spMk id="53" creationId="{6D8DAF6A-D9D3-46E5-D0A4-12BAAAF7245E}"/>
          </ac:spMkLst>
        </pc:spChg>
        <pc:picChg chg="add mod ord">
          <ac:chgData name="Kyuwoong Kim" userId="c6581f603476f281" providerId="LiveId" clId="{434244B1-39FF-4ED9-AA24-4ACBC79A9C1F}" dt="2023-12-27T02:14:20.186" v="107" actId="1076"/>
          <ac:picMkLst>
            <pc:docMk/>
            <pc:sldMk cId="648833912" sldId="256"/>
            <ac:picMk id="6" creationId="{B81BE0E0-E3FF-3DAE-7F79-A610594B98CC}"/>
          </ac:picMkLst>
        </pc:picChg>
        <pc:picChg chg="add mod ord">
          <ac:chgData name="Kyuwoong Kim" userId="c6581f603476f281" providerId="LiveId" clId="{434244B1-39FF-4ED9-AA24-4ACBC79A9C1F}" dt="2023-12-27T02:14:42.808" v="110" actId="1076"/>
          <ac:picMkLst>
            <pc:docMk/>
            <pc:sldMk cId="648833912" sldId="256"/>
            <ac:picMk id="7" creationId="{6F183281-212D-39F9-96FF-ECB777A3CFD1}"/>
          </ac:picMkLst>
        </pc:picChg>
        <pc:picChg chg="del">
          <ac:chgData name="Kyuwoong Kim" userId="c6581f603476f281" providerId="LiveId" clId="{434244B1-39FF-4ED9-AA24-4ACBC79A9C1F}" dt="2023-12-27T02:12:55.725" v="48" actId="478"/>
          <ac:picMkLst>
            <pc:docMk/>
            <pc:sldMk cId="648833912" sldId="256"/>
            <ac:picMk id="10" creationId="{6E8F5F30-EA05-DD3F-CFEC-1573D3C5887A}"/>
          </ac:picMkLst>
        </pc:picChg>
        <pc:picChg chg="del">
          <ac:chgData name="Kyuwoong Kim" userId="c6581f603476f281" providerId="LiveId" clId="{434244B1-39FF-4ED9-AA24-4ACBC79A9C1F}" dt="2023-12-27T02:12:55.246" v="47" actId="478"/>
          <ac:picMkLst>
            <pc:docMk/>
            <pc:sldMk cId="648833912" sldId="256"/>
            <ac:picMk id="14" creationId="{1D50F22C-4387-2E52-9226-D54B945B8AA0}"/>
          </ac:picMkLst>
        </pc:picChg>
        <pc:picChg chg="del">
          <ac:chgData name="Kyuwoong Kim" userId="c6581f603476f281" providerId="LiveId" clId="{434244B1-39FF-4ED9-AA24-4ACBC79A9C1F}" dt="2023-12-27T02:12:54.986" v="46" actId="478"/>
          <ac:picMkLst>
            <pc:docMk/>
            <pc:sldMk cId="648833912" sldId="256"/>
            <ac:picMk id="17" creationId="{99896B7A-B755-45D1-F514-C876883365B4}"/>
          </ac:picMkLst>
        </pc:picChg>
        <pc:picChg chg="del">
          <ac:chgData name="Kyuwoong Kim" userId="c6581f603476f281" providerId="LiveId" clId="{434244B1-39FF-4ED9-AA24-4ACBC79A9C1F}" dt="2023-12-27T02:13:02.917" v="52" actId="478"/>
          <ac:picMkLst>
            <pc:docMk/>
            <pc:sldMk cId="648833912" sldId="256"/>
            <ac:picMk id="20" creationId="{B71E88E5-FD48-0813-1C72-7E8469DE7DB1}"/>
          </ac:picMkLst>
        </pc:picChg>
        <pc:picChg chg="del">
          <ac:chgData name="Kyuwoong Kim" userId="c6581f603476f281" providerId="LiveId" clId="{434244B1-39FF-4ED9-AA24-4ACBC79A9C1F}" dt="2023-12-27T02:13:02.554" v="51" actId="478"/>
          <ac:picMkLst>
            <pc:docMk/>
            <pc:sldMk cId="648833912" sldId="256"/>
            <ac:picMk id="23" creationId="{4DD8787B-BA9B-5928-DE43-F6263BF438D3}"/>
          </ac:picMkLst>
        </pc:picChg>
        <pc:picChg chg="del">
          <ac:chgData name="Kyuwoong Kim" userId="c6581f603476f281" providerId="LiveId" clId="{434244B1-39FF-4ED9-AA24-4ACBC79A9C1F}" dt="2023-12-27T02:13:02.261" v="50" actId="478"/>
          <ac:picMkLst>
            <pc:docMk/>
            <pc:sldMk cId="648833912" sldId="256"/>
            <ac:picMk id="24" creationId="{B70F859E-E89E-9282-4035-28681FCE6962}"/>
          </ac:picMkLst>
        </pc:picChg>
        <pc:picChg chg="add mod ord">
          <ac:chgData name="Kyuwoong Kim" userId="c6581f603476f281" providerId="LiveId" clId="{434244B1-39FF-4ED9-AA24-4ACBC79A9C1F}" dt="2023-12-27T02:14:54.601" v="113" actId="14100"/>
          <ac:picMkLst>
            <pc:docMk/>
            <pc:sldMk cId="648833912" sldId="256"/>
            <ac:picMk id="25" creationId="{EF54184C-9E0D-33DC-1555-0FC7D619B7AD}"/>
          </ac:picMkLst>
        </pc:picChg>
        <pc:picChg chg="add mod ord">
          <ac:chgData name="Kyuwoong Kim" userId="c6581f603476f281" providerId="LiveId" clId="{434244B1-39FF-4ED9-AA24-4ACBC79A9C1F}" dt="2023-12-27T02:15:49.410" v="128" actId="14100"/>
          <ac:picMkLst>
            <pc:docMk/>
            <pc:sldMk cId="648833912" sldId="256"/>
            <ac:picMk id="26" creationId="{A37C3B6C-559A-93F0-A11E-C9EAC2AC6ADE}"/>
          </ac:picMkLst>
        </pc:picChg>
        <pc:picChg chg="add mod ord">
          <ac:chgData name="Kyuwoong Kim" userId="c6581f603476f281" providerId="LiveId" clId="{434244B1-39FF-4ED9-AA24-4ACBC79A9C1F}" dt="2023-12-27T02:15:26.743" v="123" actId="14100"/>
          <ac:picMkLst>
            <pc:docMk/>
            <pc:sldMk cId="648833912" sldId="256"/>
            <ac:picMk id="27" creationId="{6212F267-255A-E98F-FD6C-4C350A7A3A41}"/>
          </ac:picMkLst>
        </pc:picChg>
        <pc:picChg chg="add mod ord">
          <ac:chgData name="Kyuwoong Kim" userId="c6581f603476f281" providerId="LiveId" clId="{434244B1-39FF-4ED9-AA24-4ACBC79A9C1F}" dt="2023-12-27T02:15:15.222" v="119" actId="14100"/>
          <ac:picMkLst>
            <pc:docMk/>
            <pc:sldMk cId="648833912" sldId="256"/>
            <ac:picMk id="28" creationId="{38C628ED-07F6-7972-7D58-F38A1AABFEB2}"/>
          </ac:picMkLst>
        </pc:picChg>
      </pc:sldChg>
    </pc:docChg>
  </pc:docChgLst>
  <pc:docChgLst>
    <pc:chgData name="Kyuwoong Kim" userId="c6581f603476f281" providerId="LiveId" clId="{4C2B3B1C-2310-4AB4-A954-ADC28E335756}"/>
    <pc:docChg chg="undo custSel addSld delSld modSld sldOrd">
      <pc:chgData name="Kyuwoong Kim" userId="c6581f603476f281" providerId="LiveId" clId="{4C2B3B1C-2310-4AB4-A954-ADC28E335756}" dt="2023-12-26T06:19:09.636" v="565" actId="1076"/>
      <pc:docMkLst>
        <pc:docMk/>
      </pc:docMkLst>
      <pc:sldChg chg="addSp delSp modSp new mod">
        <pc:chgData name="Kyuwoong Kim" userId="c6581f603476f281" providerId="LiveId" clId="{4C2B3B1C-2310-4AB4-A954-ADC28E335756}" dt="2023-12-26T06:19:09.636" v="565" actId="1076"/>
        <pc:sldMkLst>
          <pc:docMk/>
          <pc:sldMk cId="648833912" sldId="256"/>
        </pc:sldMkLst>
        <pc:spChg chg="add mod">
          <ac:chgData name="Kyuwoong Kim" userId="c6581f603476f281" providerId="LiveId" clId="{4C2B3B1C-2310-4AB4-A954-ADC28E335756}" dt="2023-12-22T02:35:22.208" v="385" actId="403"/>
          <ac:spMkLst>
            <pc:docMk/>
            <pc:sldMk cId="648833912" sldId="256"/>
            <ac:spMk id="5" creationId="{FAEA2DB1-F50B-F0A4-D080-98E28C6F2E60}"/>
          </ac:spMkLst>
        </pc:spChg>
        <pc:spChg chg="add del mod">
          <ac:chgData name="Kyuwoong Kim" userId="c6581f603476f281" providerId="LiveId" clId="{4C2B3B1C-2310-4AB4-A954-ADC28E335756}" dt="2023-12-22T02:35:49.042" v="388" actId="478"/>
          <ac:spMkLst>
            <pc:docMk/>
            <pc:sldMk cId="648833912" sldId="256"/>
            <ac:spMk id="6" creationId="{E8DFCCDF-13EF-6AA2-C66C-413D916B314C}"/>
          </ac:spMkLst>
        </pc:spChg>
        <pc:spChg chg="add del mod">
          <ac:chgData name="Kyuwoong Kim" userId="c6581f603476f281" providerId="LiveId" clId="{4C2B3B1C-2310-4AB4-A954-ADC28E335756}" dt="2023-12-22T02:35:52.378" v="390" actId="478"/>
          <ac:spMkLst>
            <pc:docMk/>
            <pc:sldMk cId="648833912" sldId="256"/>
            <ac:spMk id="7" creationId="{FC4F9864-A538-399A-9F20-B807CDFC6B04}"/>
          </ac:spMkLst>
        </pc:spChg>
        <pc:spChg chg="add mod">
          <ac:chgData name="Kyuwoong Kim" userId="c6581f603476f281" providerId="LiveId" clId="{4C2B3B1C-2310-4AB4-A954-ADC28E335756}" dt="2023-12-22T02:34:12.188" v="363"/>
          <ac:spMkLst>
            <pc:docMk/>
            <pc:sldMk cId="648833912" sldId="256"/>
            <ac:spMk id="8" creationId="{D553A7A6-7D68-32A5-7273-A9A66CE3502C}"/>
          </ac:spMkLst>
        </pc:spChg>
        <pc:spChg chg="add del mod">
          <ac:chgData name="Kyuwoong Kim" userId="c6581f603476f281" providerId="LiveId" clId="{4C2B3B1C-2310-4AB4-A954-ADC28E335756}" dt="2023-12-22T02:35:44.910" v="386" actId="478"/>
          <ac:spMkLst>
            <pc:docMk/>
            <pc:sldMk cId="648833912" sldId="256"/>
            <ac:spMk id="9" creationId="{5BE2A2B9-9C8D-ECE1-16AD-619429108F39}"/>
          </ac:spMkLst>
        </pc:spChg>
        <pc:spChg chg="add del mod">
          <ac:chgData name="Kyuwoong Kim" userId="c6581f603476f281" providerId="LiveId" clId="{4C2B3B1C-2310-4AB4-A954-ADC28E335756}" dt="2023-12-22T02:36:32.109" v="404" actId="478"/>
          <ac:spMkLst>
            <pc:docMk/>
            <pc:sldMk cId="648833912" sldId="256"/>
            <ac:spMk id="10" creationId="{DCA13580-D18C-54D9-3251-C46684F83761}"/>
          </ac:spMkLst>
        </pc:spChg>
        <pc:spChg chg="add mod">
          <ac:chgData name="Kyuwoong Kim" userId="c6581f603476f281" providerId="LiveId" clId="{4C2B3B1C-2310-4AB4-A954-ADC28E335756}" dt="2023-12-26T04:40:58.141" v="562" actId="20577"/>
          <ac:spMkLst>
            <pc:docMk/>
            <pc:sldMk cId="648833912" sldId="256"/>
            <ac:spMk id="11" creationId="{1B1DC1A3-A19A-5EB6-CBBB-A2FE1234B35D}"/>
          </ac:spMkLst>
        </pc:spChg>
        <pc:spChg chg="add mod">
          <ac:chgData name="Kyuwoong Kim" userId="c6581f603476f281" providerId="LiveId" clId="{4C2B3B1C-2310-4AB4-A954-ADC28E335756}" dt="2023-12-26T04:40:53.342" v="558" actId="20577"/>
          <ac:spMkLst>
            <pc:docMk/>
            <pc:sldMk cId="648833912" sldId="256"/>
            <ac:spMk id="12" creationId="{251F90EA-C15F-4776-7BAD-D7CA740247A4}"/>
          </ac:spMkLst>
        </pc:spChg>
        <pc:spChg chg="add mod">
          <ac:chgData name="Kyuwoong Kim" userId="c6581f603476f281" providerId="LiveId" clId="{4C2B3B1C-2310-4AB4-A954-ADC28E335756}" dt="2023-12-26T04:40:49.917" v="555" actId="20577"/>
          <ac:spMkLst>
            <pc:docMk/>
            <pc:sldMk cId="648833912" sldId="256"/>
            <ac:spMk id="13" creationId="{CBA48424-BA70-4B9A-9D1F-825934D0432C}"/>
          </ac:spMkLst>
        </pc:spChg>
        <pc:spChg chg="add del mod">
          <ac:chgData name="Kyuwoong Kim" userId="c6581f603476f281" providerId="LiveId" clId="{4C2B3B1C-2310-4AB4-A954-ADC28E335756}" dt="2023-12-22T02:35:50.590" v="389" actId="478"/>
          <ac:spMkLst>
            <pc:docMk/>
            <pc:sldMk cId="648833912" sldId="256"/>
            <ac:spMk id="14" creationId="{AFE7546C-3900-27DF-723F-B5A6227063E6}"/>
          </ac:spMkLst>
        </pc:spChg>
        <pc:spChg chg="del mod">
          <ac:chgData name="Kyuwoong Kim" userId="c6581f603476f281" providerId="LiveId" clId="{4C2B3B1C-2310-4AB4-A954-ADC28E335756}" dt="2023-12-22T02:37:37.418" v="410" actId="478"/>
          <ac:spMkLst>
            <pc:docMk/>
            <pc:sldMk cId="648833912" sldId="256"/>
            <ac:spMk id="17" creationId="{EB150AC0-7753-8BC2-E551-5C7EB2C10167}"/>
          </ac:spMkLst>
        </pc:spChg>
        <pc:spChg chg="mod">
          <ac:chgData name="Kyuwoong Kim" userId="c6581f603476f281" providerId="LiveId" clId="{4C2B3B1C-2310-4AB4-A954-ADC28E335756}" dt="2023-12-22T02:13:23.548" v="39"/>
          <ac:spMkLst>
            <pc:docMk/>
            <pc:sldMk cId="648833912" sldId="256"/>
            <ac:spMk id="18" creationId="{DCEC5AD1-D57A-9C1E-C874-DA64F849726E}"/>
          </ac:spMkLst>
        </pc:spChg>
        <pc:spChg chg="mod">
          <ac:chgData name="Kyuwoong Kim" userId="c6581f603476f281" providerId="LiveId" clId="{4C2B3B1C-2310-4AB4-A954-ADC28E335756}" dt="2023-12-22T02:13:23.548" v="39"/>
          <ac:spMkLst>
            <pc:docMk/>
            <pc:sldMk cId="648833912" sldId="256"/>
            <ac:spMk id="19" creationId="{F2DA1553-E2E1-263E-8B3D-6FED535EDEF6}"/>
          </ac:spMkLst>
        </pc:spChg>
        <pc:spChg chg="add del mod">
          <ac:chgData name="Kyuwoong Kim" userId="c6581f603476f281" providerId="LiveId" clId="{4C2B3B1C-2310-4AB4-A954-ADC28E335756}" dt="2023-12-22T02:37:35.619" v="409" actId="478"/>
          <ac:spMkLst>
            <pc:docMk/>
            <pc:sldMk cId="648833912" sldId="256"/>
            <ac:spMk id="20" creationId="{F8E4B0C9-E50D-FCA4-9F0C-57A91AC04197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21" creationId="{62658A79-ED74-6FAE-981C-E7DE6217D7C6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22" creationId="{C7838085-C0D9-C2EF-2121-E2058AF99563}"/>
          </ac:spMkLst>
        </pc:spChg>
        <pc:spChg chg="add mod">
          <ac:chgData name="Kyuwoong Kim" userId="c6581f603476f281" providerId="LiveId" clId="{4C2B3B1C-2310-4AB4-A954-ADC28E335756}" dt="2023-12-26T04:40:30.152" v="534" actId="20577"/>
          <ac:spMkLst>
            <pc:docMk/>
            <pc:sldMk cId="648833912" sldId="256"/>
            <ac:spMk id="23" creationId="{8E53A1CF-FE7C-1C53-CA6B-D110B5B0CF6C}"/>
          </ac:spMkLst>
        </pc:spChg>
        <pc:spChg chg="add mod">
          <ac:chgData name="Kyuwoong Kim" userId="c6581f603476f281" providerId="LiveId" clId="{4C2B3B1C-2310-4AB4-A954-ADC28E335756}" dt="2023-12-26T04:40:37.622" v="543" actId="20577"/>
          <ac:spMkLst>
            <pc:docMk/>
            <pc:sldMk cId="648833912" sldId="256"/>
            <ac:spMk id="24" creationId="{87BEB7EB-53A9-6261-6205-F559A8E8254B}"/>
          </ac:spMkLst>
        </pc:spChg>
        <pc:spChg chg="add mod">
          <ac:chgData name="Kyuwoong Kim" userId="c6581f603476f281" providerId="LiveId" clId="{4C2B3B1C-2310-4AB4-A954-ADC28E335756}" dt="2023-12-26T04:40:46.630" v="552" actId="20577"/>
          <ac:spMkLst>
            <pc:docMk/>
            <pc:sldMk cId="648833912" sldId="256"/>
            <ac:spMk id="25" creationId="{7E968179-7680-E8FA-AAF3-46B859076AE8}"/>
          </ac:spMkLst>
        </pc:spChg>
        <pc:spChg chg="add mod">
          <ac:chgData name="Kyuwoong Kim" userId="c6581f603476f281" providerId="LiveId" clId="{4C2B3B1C-2310-4AB4-A954-ADC28E335756}" dt="2023-12-22T02:36:00.888" v="392" actId="1076"/>
          <ac:spMkLst>
            <pc:docMk/>
            <pc:sldMk cId="648833912" sldId="256"/>
            <ac:spMk id="28" creationId="{6CC523FB-2017-9330-E464-B51CED8C8523}"/>
          </ac:spMkLst>
        </pc:spChg>
        <pc:spChg chg="add mod">
          <ac:chgData name="Kyuwoong Kim" userId="c6581f603476f281" providerId="LiveId" clId="{4C2B3B1C-2310-4AB4-A954-ADC28E335756}" dt="2023-12-22T02:36:00.888" v="392" actId="1076"/>
          <ac:spMkLst>
            <pc:docMk/>
            <pc:sldMk cId="648833912" sldId="256"/>
            <ac:spMk id="29" creationId="{84D997AF-10C2-7BCE-7E4B-900B41D3F831}"/>
          </ac:spMkLst>
        </pc:spChg>
        <pc:spChg chg="add mod">
          <ac:chgData name="Kyuwoong Kim" userId="c6581f603476f281" providerId="LiveId" clId="{4C2B3B1C-2310-4AB4-A954-ADC28E335756}" dt="2023-12-22T02:36:16.163" v="395" actId="1076"/>
          <ac:spMkLst>
            <pc:docMk/>
            <pc:sldMk cId="648833912" sldId="256"/>
            <ac:spMk id="30" creationId="{4335569D-7366-F6A9-F34B-05B3CA2358D7}"/>
          </ac:spMkLst>
        </pc:spChg>
        <pc:spChg chg="add mod">
          <ac:chgData name="Kyuwoong Kim" userId="c6581f603476f281" providerId="LiveId" clId="{4C2B3B1C-2310-4AB4-A954-ADC28E335756}" dt="2023-12-22T02:37:25.698" v="408" actId="1076"/>
          <ac:spMkLst>
            <pc:docMk/>
            <pc:sldMk cId="648833912" sldId="256"/>
            <ac:spMk id="31" creationId="{3E544B73-14FB-8C0A-54BB-F1BA0C604724}"/>
          </ac:spMkLst>
        </pc:spChg>
        <pc:spChg chg="add mod">
          <ac:chgData name="Kyuwoong Kim" userId="c6581f603476f281" providerId="LiveId" clId="{4C2B3B1C-2310-4AB4-A954-ADC28E335756}" dt="2023-12-22T02:41:32.130" v="482"/>
          <ac:spMkLst>
            <pc:docMk/>
            <pc:sldMk cId="648833912" sldId="256"/>
            <ac:spMk id="32" creationId="{4678528B-DB09-94AB-B587-41D5198D9A26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3" creationId="{61971DD9-EE9D-3C64-F8DD-8183D3D3456F}"/>
          </ac:spMkLst>
        </pc:spChg>
        <pc:spChg chg="add mod">
          <ac:chgData name="Kyuwoong Kim" userId="c6581f603476f281" providerId="LiveId" clId="{4C2B3B1C-2310-4AB4-A954-ADC28E335756}" dt="2023-12-22T02:40:11.026" v="459"/>
          <ac:spMkLst>
            <pc:docMk/>
            <pc:sldMk cId="648833912" sldId="256"/>
            <ac:spMk id="34" creationId="{80FA53D5-FEE6-02E5-6DE0-C9E26F2331AB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5" creationId="{3B5806F3-36F5-6DF5-0AF2-60DF275BB797}"/>
          </ac:spMkLst>
        </pc:spChg>
        <pc:spChg chg="add mod">
          <ac:chgData name="Kyuwoong Kim" userId="c6581f603476f281" providerId="LiveId" clId="{4C2B3B1C-2310-4AB4-A954-ADC28E335756}" dt="2023-12-22T02:41:05.901" v="477"/>
          <ac:spMkLst>
            <pc:docMk/>
            <pc:sldMk cId="648833912" sldId="256"/>
            <ac:spMk id="36" creationId="{B7EEE248-8304-9643-3D5B-3A97CA501CAE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7" creationId="{5179028C-B7AA-2FD1-3382-46A04DAF1845}"/>
          </ac:spMkLst>
        </pc:spChg>
        <pc:grpChg chg="add mod">
          <ac:chgData name="Kyuwoong Kim" userId="c6581f603476f281" providerId="LiveId" clId="{4C2B3B1C-2310-4AB4-A954-ADC28E335756}" dt="2023-12-22T02:39:40.130" v="436" actId="1076"/>
          <ac:grpSpMkLst>
            <pc:docMk/>
            <pc:sldMk cId="648833912" sldId="256"/>
            <ac:grpSpMk id="16" creationId="{DF6075C8-D9A8-1BA5-6729-88B15C885B2D}"/>
          </ac:grpSpMkLst>
        </pc:grpChg>
        <pc:picChg chg="add mod">
          <ac:chgData name="Kyuwoong Kim" userId="c6581f603476f281" providerId="LiveId" clId="{4C2B3B1C-2310-4AB4-A954-ADC28E335756}" dt="2023-12-26T06:19:00.434" v="563" actId="1076"/>
          <ac:picMkLst>
            <pc:docMk/>
            <pc:sldMk cId="648833912" sldId="256"/>
            <ac:picMk id="2" creationId="{A7E0DEB9-D172-D4CE-9CC1-F9C55B63D1A8}"/>
          </ac:picMkLst>
        </pc:picChg>
        <pc:picChg chg="add mod">
          <ac:chgData name="Kyuwoong Kim" userId="c6581f603476f281" providerId="LiveId" clId="{4C2B3B1C-2310-4AB4-A954-ADC28E335756}" dt="2023-12-22T02:13:03.330" v="38" actId="1076"/>
          <ac:picMkLst>
            <pc:docMk/>
            <pc:sldMk cId="648833912" sldId="256"/>
            <ac:picMk id="3" creationId="{A0A6CB00-12F0-B4E9-88A2-B06026F9DA91}"/>
          </ac:picMkLst>
        </pc:picChg>
        <pc:picChg chg="add mod">
          <ac:chgData name="Kyuwoong Kim" userId="c6581f603476f281" providerId="LiveId" clId="{4C2B3B1C-2310-4AB4-A954-ADC28E335756}" dt="2023-12-22T02:13:03.330" v="38" actId="1076"/>
          <ac:picMkLst>
            <pc:docMk/>
            <pc:sldMk cId="648833912" sldId="256"/>
            <ac:picMk id="4" creationId="{F3923BCE-31B9-CA0F-397E-B63633BEBADB}"/>
          </ac:picMkLst>
        </pc:picChg>
        <pc:picChg chg="add mod">
          <ac:chgData name="Kyuwoong Kim" userId="c6581f603476f281" providerId="LiveId" clId="{4C2B3B1C-2310-4AB4-A954-ADC28E335756}" dt="2023-12-26T06:19:09.636" v="565" actId="1076"/>
          <ac:picMkLst>
            <pc:docMk/>
            <pc:sldMk cId="648833912" sldId="256"/>
            <ac:picMk id="15" creationId="{23B2810A-7602-6CA4-4CB2-C591CF3DA2A5}"/>
          </ac:picMkLst>
        </pc:picChg>
        <pc:picChg chg="add mod">
          <ac:chgData name="Kyuwoong Kim" userId="c6581f603476f281" providerId="LiveId" clId="{4C2B3B1C-2310-4AB4-A954-ADC28E335756}" dt="2023-12-22T02:39:40.130" v="436" actId="1076"/>
          <ac:picMkLst>
            <pc:docMk/>
            <pc:sldMk cId="648833912" sldId="256"/>
            <ac:picMk id="26" creationId="{07FCE925-4484-CCCE-19AD-B78566DC0BC1}"/>
          </ac:picMkLst>
        </pc:picChg>
        <pc:picChg chg="add mod">
          <ac:chgData name="Kyuwoong Kim" userId="c6581f603476f281" providerId="LiveId" clId="{4C2B3B1C-2310-4AB4-A954-ADC28E335756}" dt="2023-12-26T06:19:03.632" v="564" actId="1076"/>
          <ac:picMkLst>
            <pc:docMk/>
            <pc:sldMk cId="648833912" sldId="256"/>
            <ac:picMk id="27" creationId="{250591F6-C4B2-33FA-F314-E5035DD94202}"/>
          </ac:picMkLst>
        </pc:picChg>
      </pc:sldChg>
      <pc:sldChg chg="del">
        <pc:chgData name="Kyuwoong Kim" userId="c6581f603476f281" providerId="LiveId" clId="{4C2B3B1C-2310-4AB4-A954-ADC28E335756}" dt="2023-12-22T02:10:32.383" v="2" actId="47"/>
        <pc:sldMkLst>
          <pc:docMk/>
          <pc:sldMk cId="3235639082" sldId="258"/>
        </pc:sldMkLst>
      </pc:sldChg>
      <pc:sldChg chg="del ord">
        <pc:chgData name="Kyuwoong Kim" userId="c6581f603476f281" providerId="LiveId" clId="{4C2B3B1C-2310-4AB4-A954-ADC28E335756}" dt="2023-12-22T02:10:32.897" v="3" actId="47"/>
        <pc:sldMkLst>
          <pc:docMk/>
          <pc:sldMk cId="1812910984" sldId="260"/>
        </pc:sldMkLst>
      </pc:sldChg>
    </pc:docChg>
  </pc:docChgLst>
  <pc:docChgLst>
    <pc:chgData name="Kyuwoong Kim" userId="c6581f603476f281" providerId="LiveId" clId="{0C69991C-9789-43E4-BED0-0659299C4FE5}"/>
    <pc:docChg chg="undo custSel modSld">
      <pc:chgData name="Kyuwoong Kim" userId="c6581f603476f281" providerId="LiveId" clId="{0C69991C-9789-43E4-BED0-0659299C4FE5}" dt="2023-12-27T02:09:51.010" v="392" actId="1076"/>
      <pc:docMkLst>
        <pc:docMk/>
      </pc:docMkLst>
      <pc:sldChg chg="addSp delSp modSp mod">
        <pc:chgData name="Kyuwoong Kim" userId="c6581f603476f281" providerId="LiveId" clId="{0C69991C-9789-43E4-BED0-0659299C4FE5}" dt="2023-12-27T02:09:51.010" v="392" actId="1076"/>
        <pc:sldMkLst>
          <pc:docMk/>
          <pc:sldMk cId="648833912" sldId="256"/>
        </pc:sldMkLst>
        <pc:spChg chg="mod">
          <ac:chgData name="Kyuwoong Kim" userId="c6581f603476f281" providerId="LiveId" clId="{0C69991C-9789-43E4-BED0-0659299C4FE5}" dt="2023-12-27T01:50:49.726" v="149" actId="20577"/>
          <ac:spMkLst>
            <pc:docMk/>
            <pc:sldMk cId="648833912" sldId="256"/>
            <ac:spMk id="2" creationId="{FD3CC9AA-26FA-3AD2-5616-B24CBD74D53A}"/>
          </ac:spMkLst>
        </pc:spChg>
        <pc:spChg chg="mod">
          <ac:chgData name="Kyuwoong Kim" userId="c6581f603476f281" providerId="LiveId" clId="{0C69991C-9789-43E4-BED0-0659299C4FE5}" dt="2023-12-27T01:54:42.282" v="288"/>
          <ac:spMkLst>
            <pc:docMk/>
            <pc:sldMk cId="648833912" sldId="256"/>
            <ac:spMk id="5" creationId="{027AA216-DF50-0D66-EF32-BD54A8AA60B5}"/>
          </ac:spMkLst>
        </pc:spChg>
        <pc:spChg chg="mod">
          <ac:chgData name="Kyuwoong Kim" userId="c6581f603476f281" providerId="LiveId" clId="{0C69991C-9789-43E4-BED0-0659299C4FE5}" dt="2023-12-27T01:50:57.818" v="155" actId="20577"/>
          <ac:spMkLst>
            <pc:docMk/>
            <pc:sldMk cId="648833912" sldId="256"/>
            <ac:spMk id="8" creationId="{97DD32AB-1146-40EB-3909-3D199FAB0E30}"/>
          </ac:spMkLst>
        </pc:spChg>
        <pc:spChg chg="mod">
          <ac:chgData name="Kyuwoong Kim" userId="c6581f603476f281" providerId="LiveId" clId="{0C69991C-9789-43E4-BED0-0659299C4FE5}" dt="2023-12-27T01:49:28.491" v="100" actId="20577"/>
          <ac:spMkLst>
            <pc:docMk/>
            <pc:sldMk cId="648833912" sldId="256"/>
            <ac:spMk id="9" creationId="{C38CFEB1-5D97-15BA-1BB8-A579D9511F5B}"/>
          </ac:spMkLst>
        </pc:spChg>
        <pc:spChg chg="mod">
          <ac:chgData name="Kyuwoong Kim" userId="c6581f603476f281" providerId="LiveId" clId="{0C69991C-9789-43E4-BED0-0659299C4FE5}" dt="2023-12-27T01:54:49.308" v="290"/>
          <ac:spMkLst>
            <pc:docMk/>
            <pc:sldMk cId="648833912" sldId="256"/>
            <ac:spMk id="11" creationId="{94EFB512-D4E6-2BFA-E7B7-A4AF376B498D}"/>
          </ac:spMkLst>
        </pc:spChg>
        <pc:spChg chg="mod">
          <ac:chgData name="Kyuwoong Kim" userId="c6581f603476f281" providerId="LiveId" clId="{0C69991C-9789-43E4-BED0-0659299C4FE5}" dt="2023-12-27T01:51:08.872" v="164" actId="20577"/>
          <ac:spMkLst>
            <pc:docMk/>
            <pc:sldMk cId="648833912" sldId="256"/>
            <ac:spMk id="12" creationId="{7E9BFFAB-13B8-AF42-8201-87FBFDA58E42}"/>
          </ac:spMkLst>
        </pc:spChg>
        <pc:spChg chg="mod">
          <ac:chgData name="Kyuwoong Kim" userId="c6581f603476f281" providerId="LiveId" clId="{0C69991C-9789-43E4-BED0-0659299C4FE5}" dt="2023-12-27T01:57:15.533" v="390" actId="1076"/>
          <ac:spMkLst>
            <pc:docMk/>
            <pc:sldMk cId="648833912" sldId="256"/>
            <ac:spMk id="13" creationId="{D471E572-B0C6-999F-59C2-61AD127B40F1}"/>
          </ac:spMkLst>
        </pc:spChg>
        <pc:spChg chg="mod">
          <ac:chgData name="Kyuwoong Kim" userId="c6581f603476f281" providerId="LiveId" clId="{0C69991C-9789-43E4-BED0-0659299C4FE5}" dt="2023-12-27T01:51:19.737" v="170" actId="20577"/>
          <ac:spMkLst>
            <pc:docMk/>
            <pc:sldMk cId="648833912" sldId="256"/>
            <ac:spMk id="15" creationId="{832C9E58-ED44-A228-42DE-08C68783B30B}"/>
          </ac:spMkLst>
        </pc:spChg>
        <pc:spChg chg="mod">
          <ac:chgData name="Kyuwoong Kim" userId="c6581f603476f281" providerId="LiveId" clId="{0C69991C-9789-43E4-BED0-0659299C4FE5}" dt="2023-12-27T01:56:56.094" v="384" actId="1076"/>
          <ac:spMkLst>
            <pc:docMk/>
            <pc:sldMk cId="648833912" sldId="256"/>
            <ac:spMk id="16" creationId="{A115F86F-7F57-9521-2997-8B0366BA61C1}"/>
          </ac:spMkLst>
        </pc:spChg>
        <pc:spChg chg="mod">
          <ac:chgData name="Kyuwoong Kim" userId="c6581f603476f281" providerId="LiveId" clId="{0C69991C-9789-43E4-BED0-0659299C4FE5}" dt="2023-12-27T02:09:37.227" v="391" actId="1076"/>
          <ac:spMkLst>
            <pc:docMk/>
            <pc:sldMk cId="648833912" sldId="256"/>
            <ac:spMk id="18" creationId="{2C7B121F-3BEF-3CE1-756F-B8BCEA464733}"/>
          </ac:spMkLst>
        </pc:spChg>
        <pc:spChg chg="mod">
          <ac:chgData name="Kyuwoong Kim" userId="c6581f603476f281" providerId="LiveId" clId="{0C69991C-9789-43E4-BED0-0659299C4FE5}" dt="2023-12-27T01:56:52.550" v="383" actId="1076"/>
          <ac:spMkLst>
            <pc:docMk/>
            <pc:sldMk cId="648833912" sldId="256"/>
            <ac:spMk id="19" creationId="{C19EFB19-09EC-89F1-A1C2-F48AD3F1B295}"/>
          </ac:spMkLst>
        </pc:spChg>
        <pc:spChg chg="mod">
          <ac:chgData name="Kyuwoong Kim" userId="c6581f603476f281" providerId="LiveId" clId="{0C69991C-9789-43E4-BED0-0659299C4FE5}" dt="2023-12-27T02:09:51.010" v="392" actId="1076"/>
          <ac:spMkLst>
            <pc:docMk/>
            <pc:sldMk cId="648833912" sldId="256"/>
            <ac:spMk id="21" creationId="{52B25AC5-F550-547A-7C3C-5CC42318BBBC}"/>
          </ac:spMkLst>
        </pc:spChg>
        <pc:spChg chg="mod">
          <ac:chgData name="Kyuwoong Kim" userId="c6581f603476f281" providerId="LiveId" clId="{0C69991C-9789-43E4-BED0-0659299C4FE5}" dt="2023-12-27T01:57:12.492" v="389" actId="1076"/>
          <ac:spMkLst>
            <pc:docMk/>
            <pc:sldMk cId="648833912" sldId="256"/>
            <ac:spMk id="22" creationId="{F38EBE54-0362-C1B9-13EE-13306B3E6B30}"/>
          </ac:spMkLst>
        </pc:spChg>
        <pc:spChg chg="mod">
          <ac:chgData name="Kyuwoong Kim" userId="c6581f603476f281" providerId="LiveId" clId="{0C69991C-9789-43E4-BED0-0659299C4FE5}" dt="2023-12-27T01:52:39.182" v="231" actId="20577"/>
          <ac:spMkLst>
            <pc:docMk/>
            <pc:sldMk cId="648833912" sldId="256"/>
            <ac:spMk id="38" creationId="{549A40D2-B161-41AC-AD42-9BBE11DBEF59}"/>
          </ac:spMkLst>
        </pc:spChg>
        <pc:spChg chg="mod">
          <ac:chgData name="Kyuwoong Kim" userId="c6581f603476f281" providerId="LiveId" clId="{0C69991C-9789-43E4-BED0-0659299C4FE5}" dt="2023-12-27T01:52:58.777" v="248" actId="20577"/>
          <ac:spMkLst>
            <pc:docMk/>
            <pc:sldMk cId="648833912" sldId="256"/>
            <ac:spMk id="39" creationId="{0C2D4290-83CA-546A-268C-60FFDCA6B305}"/>
          </ac:spMkLst>
        </pc:spChg>
        <pc:spChg chg="mod">
          <ac:chgData name="Kyuwoong Kim" userId="c6581f603476f281" providerId="LiveId" clId="{0C69991C-9789-43E4-BED0-0659299C4FE5}" dt="2023-12-27T01:53:23.958" v="264" actId="20577"/>
          <ac:spMkLst>
            <pc:docMk/>
            <pc:sldMk cId="648833912" sldId="256"/>
            <ac:spMk id="40" creationId="{90309B63-1CFE-2EFE-B9B5-8D7A365C6ACC}"/>
          </ac:spMkLst>
        </pc:spChg>
        <pc:spChg chg="mod">
          <ac:chgData name="Kyuwoong Kim" userId="c6581f603476f281" providerId="LiveId" clId="{0C69991C-9789-43E4-BED0-0659299C4FE5}" dt="2023-12-27T01:55:36.995" v="316" actId="20577"/>
          <ac:spMkLst>
            <pc:docMk/>
            <pc:sldMk cId="648833912" sldId="256"/>
            <ac:spMk id="51" creationId="{958350B1-BEF6-2452-8208-F4A3A8ED5EA4}"/>
          </ac:spMkLst>
        </pc:spChg>
        <pc:spChg chg="mod">
          <ac:chgData name="Kyuwoong Kim" userId="c6581f603476f281" providerId="LiveId" clId="{0C69991C-9789-43E4-BED0-0659299C4FE5}" dt="2023-12-27T01:55:56.926" v="343" actId="20577"/>
          <ac:spMkLst>
            <pc:docMk/>
            <pc:sldMk cId="648833912" sldId="256"/>
            <ac:spMk id="52" creationId="{AF566DC3-DBE2-50A7-D072-B6DF87688FC9}"/>
          </ac:spMkLst>
        </pc:spChg>
        <pc:spChg chg="mod">
          <ac:chgData name="Kyuwoong Kim" userId="c6581f603476f281" providerId="LiveId" clId="{0C69991C-9789-43E4-BED0-0659299C4FE5}" dt="2023-12-27T01:56:22.260" v="374" actId="20577"/>
          <ac:spMkLst>
            <pc:docMk/>
            <pc:sldMk cId="648833912" sldId="256"/>
            <ac:spMk id="53" creationId="{6D8DAF6A-D9D3-46E5-D0A4-12BAAAF7245E}"/>
          </ac:spMkLst>
        </pc:spChg>
        <pc:picChg chg="del">
          <ac:chgData name="Kyuwoong Kim" userId="c6581f603476f281" providerId="LiveId" clId="{0C69991C-9789-43E4-BED0-0659299C4FE5}" dt="2023-12-27T01:50:11.654" v="125" actId="478"/>
          <ac:picMkLst>
            <pc:docMk/>
            <pc:sldMk cId="648833912" sldId="256"/>
            <ac:picMk id="6" creationId="{2E0E3B99-2D8A-1654-1D9E-E8E5DC6EE455}"/>
          </ac:picMkLst>
        </pc:picChg>
        <pc:picChg chg="del">
          <ac:chgData name="Kyuwoong Kim" userId="c6581f603476f281" providerId="LiveId" clId="{0C69991C-9789-43E4-BED0-0659299C4FE5}" dt="2023-12-27T01:50:11.147" v="124" actId="478"/>
          <ac:picMkLst>
            <pc:docMk/>
            <pc:sldMk cId="648833912" sldId="256"/>
            <ac:picMk id="7" creationId="{6EC75941-0253-1363-18C9-092E3CF758D1}"/>
          </ac:picMkLst>
        </pc:picChg>
        <pc:picChg chg="add mod ord">
          <ac:chgData name="Kyuwoong Kim" userId="c6581f603476f281" providerId="LiveId" clId="{0C69991C-9789-43E4-BED0-0659299C4FE5}" dt="2023-12-27T01:54:10.395" v="280" actId="14100"/>
          <ac:picMkLst>
            <pc:docMk/>
            <pc:sldMk cId="648833912" sldId="256"/>
            <ac:picMk id="10" creationId="{6E8F5F30-EA05-DD3F-CFEC-1573D3C5887A}"/>
          </ac:picMkLst>
        </pc:picChg>
        <pc:picChg chg="add mod ord">
          <ac:chgData name="Kyuwoong Kim" userId="c6581f603476f281" providerId="LiveId" clId="{0C69991C-9789-43E4-BED0-0659299C4FE5}" dt="2023-12-27T01:54:01.677" v="277" actId="1076"/>
          <ac:picMkLst>
            <pc:docMk/>
            <pc:sldMk cId="648833912" sldId="256"/>
            <ac:picMk id="14" creationId="{1D50F22C-4387-2E52-9226-D54B945B8AA0}"/>
          </ac:picMkLst>
        </pc:picChg>
        <pc:picChg chg="add mod ord">
          <ac:chgData name="Kyuwoong Kim" userId="c6581f603476f281" providerId="LiveId" clId="{0C69991C-9789-43E4-BED0-0659299C4FE5}" dt="2023-12-27T01:53:50.692" v="272" actId="1076"/>
          <ac:picMkLst>
            <pc:docMk/>
            <pc:sldMk cId="648833912" sldId="256"/>
            <ac:picMk id="17" creationId="{99896B7A-B755-45D1-F514-C876883365B4}"/>
          </ac:picMkLst>
        </pc:picChg>
        <pc:picChg chg="add mod ord">
          <ac:chgData name="Kyuwoong Kim" userId="c6581f603476f281" providerId="LiveId" clId="{0C69991C-9789-43E4-BED0-0659299C4FE5}" dt="2023-12-27T01:57:07.124" v="388" actId="14100"/>
          <ac:picMkLst>
            <pc:docMk/>
            <pc:sldMk cId="648833912" sldId="256"/>
            <ac:picMk id="20" creationId="{B71E88E5-FD48-0813-1C72-7E8469DE7DB1}"/>
          </ac:picMkLst>
        </pc:picChg>
        <pc:picChg chg="add mod ord">
          <ac:chgData name="Kyuwoong Kim" userId="c6581f603476f281" providerId="LiveId" clId="{0C69991C-9789-43E4-BED0-0659299C4FE5}" dt="2023-12-27T01:56:49.275" v="382" actId="14100"/>
          <ac:picMkLst>
            <pc:docMk/>
            <pc:sldMk cId="648833912" sldId="256"/>
            <ac:picMk id="23" creationId="{4DD8787B-BA9B-5928-DE43-F6263BF438D3}"/>
          </ac:picMkLst>
        </pc:picChg>
        <pc:picChg chg="add mod ord">
          <ac:chgData name="Kyuwoong Kim" userId="c6581f603476f281" providerId="LiveId" clId="{0C69991C-9789-43E4-BED0-0659299C4FE5}" dt="2023-12-27T01:56:45.868" v="380" actId="1076"/>
          <ac:picMkLst>
            <pc:docMk/>
            <pc:sldMk cId="648833912" sldId="256"/>
            <ac:picMk id="24" creationId="{B70F859E-E89E-9282-4035-28681FCE6962}"/>
          </ac:picMkLst>
        </pc:picChg>
        <pc:picChg chg="del">
          <ac:chgData name="Kyuwoong Kim" userId="c6581f603476f281" providerId="LiveId" clId="{0C69991C-9789-43E4-BED0-0659299C4FE5}" dt="2023-12-27T01:50:10.777" v="123" actId="478"/>
          <ac:picMkLst>
            <pc:docMk/>
            <pc:sldMk cId="648833912" sldId="256"/>
            <ac:picMk id="41" creationId="{5A214A41-6125-1A42-AE2D-79CB4584ECFD}"/>
          </ac:picMkLst>
        </pc:picChg>
        <pc:picChg chg="del">
          <ac:chgData name="Kyuwoong Kim" userId="c6581f603476f281" providerId="LiveId" clId="{0C69991C-9789-43E4-BED0-0659299C4FE5}" dt="2023-12-27T01:50:13.181" v="128" actId="478"/>
          <ac:picMkLst>
            <pc:docMk/>
            <pc:sldMk cId="648833912" sldId="256"/>
            <ac:picMk id="42" creationId="{6F25A9B9-D76D-3E46-25B7-79D914A658F2}"/>
          </ac:picMkLst>
        </pc:picChg>
        <pc:picChg chg="del">
          <ac:chgData name="Kyuwoong Kim" userId="c6581f603476f281" providerId="LiveId" clId="{0C69991C-9789-43E4-BED0-0659299C4FE5}" dt="2023-12-27T01:50:12.503" v="127" actId="478"/>
          <ac:picMkLst>
            <pc:docMk/>
            <pc:sldMk cId="648833912" sldId="256"/>
            <ac:picMk id="43" creationId="{AF8077C5-FE9A-A0AF-1A5A-CD3D3B7AE75E}"/>
          </ac:picMkLst>
        </pc:picChg>
        <pc:picChg chg="del">
          <ac:chgData name="Kyuwoong Kim" userId="c6581f603476f281" providerId="LiveId" clId="{0C69991C-9789-43E4-BED0-0659299C4FE5}" dt="2023-12-27T01:50:12.089" v="126" actId="478"/>
          <ac:picMkLst>
            <pc:docMk/>
            <pc:sldMk cId="648833912" sldId="256"/>
            <ac:picMk id="44" creationId="{3D3F847B-2BE8-9E25-E12D-17BCDF229CB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8455" y="1797080"/>
            <a:ext cx="10975816" cy="3822924"/>
          </a:xfrm>
        </p:spPr>
        <p:txBody>
          <a:bodyPr anchor="b"/>
          <a:lstStyle>
            <a:lvl1pPr algn="ctr">
              <a:defRPr sz="847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14091" y="5767430"/>
            <a:ext cx="9684544" cy="2651136"/>
          </a:xfrm>
        </p:spPr>
        <p:txBody>
          <a:bodyPr/>
          <a:lstStyle>
            <a:lvl1pPr marL="0" indent="0" algn="ctr">
              <a:buNone/>
              <a:defRPr sz="3389"/>
            </a:lvl1pPr>
            <a:lvl2pPr marL="645658" indent="0" algn="ctr">
              <a:buNone/>
              <a:defRPr sz="2824"/>
            </a:lvl2pPr>
            <a:lvl3pPr marL="1291316" indent="0" algn="ctr">
              <a:buNone/>
              <a:defRPr sz="2542"/>
            </a:lvl3pPr>
            <a:lvl4pPr marL="1936974" indent="0" algn="ctr">
              <a:buNone/>
              <a:defRPr sz="2260"/>
            </a:lvl4pPr>
            <a:lvl5pPr marL="2582631" indent="0" algn="ctr">
              <a:buNone/>
              <a:defRPr sz="2260"/>
            </a:lvl5pPr>
            <a:lvl6pPr marL="3228289" indent="0" algn="ctr">
              <a:buNone/>
              <a:defRPr sz="2260"/>
            </a:lvl6pPr>
            <a:lvl7pPr marL="3873947" indent="0" algn="ctr">
              <a:buNone/>
              <a:defRPr sz="2260"/>
            </a:lvl7pPr>
            <a:lvl8pPr marL="4519605" indent="0" algn="ctr">
              <a:buNone/>
              <a:defRPr sz="2260"/>
            </a:lvl8pPr>
            <a:lvl9pPr marL="5165263" indent="0" algn="ctr">
              <a:buNone/>
              <a:defRPr sz="226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3346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8627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40670" y="584623"/>
            <a:ext cx="2784306" cy="930566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7751" y="584623"/>
            <a:ext cx="8191510" cy="930566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8661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456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025" y="2737562"/>
            <a:ext cx="11137225" cy="4567681"/>
          </a:xfrm>
        </p:spPr>
        <p:txBody>
          <a:bodyPr anchor="b"/>
          <a:lstStyle>
            <a:lvl1pPr>
              <a:defRPr sz="847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025" y="7348455"/>
            <a:ext cx="11137225" cy="2402036"/>
          </a:xfrm>
        </p:spPr>
        <p:txBody>
          <a:bodyPr/>
          <a:lstStyle>
            <a:lvl1pPr marL="0" indent="0">
              <a:buNone/>
              <a:defRPr sz="3389">
                <a:solidFill>
                  <a:schemeClr val="tx1"/>
                </a:solidFill>
              </a:defRPr>
            </a:lvl1pPr>
            <a:lvl2pPr marL="645658" indent="0">
              <a:buNone/>
              <a:defRPr sz="2824">
                <a:solidFill>
                  <a:schemeClr val="tx1">
                    <a:tint val="75000"/>
                  </a:schemeClr>
                </a:solidFill>
              </a:defRPr>
            </a:lvl2pPr>
            <a:lvl3pPr marL="1291316" indent="0">
              <a:buNone/>
              <a:defRPr sz="2542">
                <a:solidFill>
                  <a:schemeClr val="tx1">
                    <a:tint val="75000"/>
                  </a:schemeClr>
                </a:solidFill>
              </a:defRPr>
            </a:lvl3pPr>
            <a:lvl4pPr marL="1936974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4pPr>
            <a:lvl5pPr marL="2582631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5pPr>
            <a:lvl6pPr marL="3228289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6pPr>
            <a:lvl7pPr marL="3873947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7pPr>
            <a:lvl8pPr marL="451960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8pPr>
            <a:lvl9pPr marL="5165263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569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7750" y="2923113"/>
            <a:ext cx="5487908" cy="69671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37067" y="2923113"/>
            <a:ext cx="5487908" cy="69671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4982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584625"/>
            <a:ext cx="11137225" cy="212243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9433" y="2691807"/>
            <a:ext cx="5462687" cy="1319213"/>
          </a:xfrm>
        </p:spPr>
        <p:txBody>
          <a:bodyPr anchor="b"/>
          <a:lstStyle>
            <a:lvl1pPr marL="0" indent="0">
              <a:buNone/>
              <a:defRPr sz="3389" b="1"/>
            </a:lvl1pPr>
            <a:lvl2pPr marL="645658" indent="0">
              <a:buNone/>
              <a:defRPr sz="2824" b="1"/>
            </a:lvl2pPr>
            <a:lvl3pPr marL="1291316" indent="0">
              <a:buNone/>
              <a:defRPr sz="2542" b="1"/>
            </a:lvl3pPr>
            <a:lvl4pPr marL="1936974" indent="0">
              <a:buNone/>
              <a:defRPr sz="2260" b="1"/>
            </a:lvl4pPr>
            <a:lvl5pPr marL="2582631" indent="0">
              <a:buNone/>
              <a:defRPr sz="2260" b="1"/>
            </a:lvl5pPr>
            <a:lvl6pPr marL="3228289" indent="0">
              <a:buNone/>
              <a:defRPr sz="2260" b="1"/>
            </a:lvl6pPr>
            <a:lvl7pPr marL="3873947" indent="0">
              <a:buNone/>
              <a:defRPr sz="2260" b="1"/>
            </a:lvl7pPr>
            <a:lvl8pPr marL="4519605" indent="0">
              <a:buNone/>
              <a:defRPr sz="2260" b="1"/>
            </a:lvl8pPr>
            <a:lvl9pPr marL="5165263" indent="0">
              <a:buNone/>
              <a:defRPr sz="22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9433" y="4011019"/>
            <a:ext cx="5462687" cy="589960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37068" y="2691807"/>
            <a:ext cx="5489590" cy="1319213"/>
          </a:xfrm>
        </p:spPr>
        <p:txBody>
          <a:bodyPr anchor="b"/>
          <a:lstStyle>
            <a:lvl1pPr marL="0" indent="0">
              <a:buNone/>
              <a:defRPr sz="3389" b="1"/>
            </a:lvl1pPr>
            <a:lvl2pPr marL="645658" indent="0">
              <a:buNone/>
              <a:defRPr sz="2824" b="1"/>
            </a:lvl2pPr>
            <a:lvl3pPr marL="1291316" indent="0">
              <a:buNone/>
              <a:defRPr sz="2542" b="1"/>
            </a:lvl3pPr>
            <a:lvl4pPr marL="1936974" indent="0">
              <a:buNone/>
              <a:defRPr sz="2260" b="1"/>
            </a:lvl4pPr>
            <a:lvl5pPr marL="2582631" indent="0">
              <a:buNone/>
              <a:defRPr sz="2260" b="1"/>
            </a:lvl5pPr>
            <a:lvl6pPr marL="3228289" indent="0">
              <a:buNone/>
              <a:defRPr sz="2260" b="1"/>
            </a:lvl6pPr>
            <a:lvl7pPr marL="3873947" indent="0">
              <a:buNone/>
              <a:defRPr sz="2260" b="1"/>
            </a:lvl7pPr>
            <a:lvl8pPr marL="4519605" indent="0">
              <a:buNone/>
              <a:defRPr sz="2260" b="1"/>
            </a:lvl8pPr>
            <a:lvl9pPr marL="5165263" indent="0">
              <a:buNone/>
              <a:defRPr sz="22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37068" y="4011019"/>
            <a:ext cx="5489590" cy="589960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5129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6185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3781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732049"/>
            <a:ext cx="4164690" cy="2562172"/>
          </a:xfrm>
        </p:spPr>
        <p:txBody>
          <a:bodyPr anchor="b"/>
          <a:lstStyle>
            <a:lvl1pPr>
              <a:defRPr sz="45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89590" y="1581025"/>
            <a:ext cx="6537067" cy="7803441"/>
          </a:xfrm>
        </p:spPr>
        <p:txBody>
          <a:bodyPr/>
          <a:lstStyle>
            <a:lvl1pPr>
              <a:defRPr sz="4519"/>
            </a:lvl1pPr>
            <a:lvl2pPr>
              <a:defRPr sz="3954"/>
            </a:lvl2pPr>
            <a:lvl3pPr>
              <a:defRPr sz="3389"/>
            </a:lvl3pPr>
            <a:lvl4pPr>
              <a:defRPr sz="2824"/>
            </a:lvl4pPr>
            <a:lvl5pPr>
              <a:defRPr sz="2824"/>
            </a:lvl5pPr>
            <a:lvl6pPr>
              <a:defRPr sz="2824"/>
            </a:lvl6pPr>
            <a:lvl7pPr>
              <a:defRPr sz="2824"/>
            </a:lvl7pPr>
            <a:lvl8pPr>
              <a:defRPr sz="2824"/>
            </a:lvl8pPr>
            <a:lvl9pPr>
              <a:defRPr sz="282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3294221"/>
            <a:ext cx="4164690" cy="6102953"/>
          </a:xfrm>
        </p:spPr>
        <p:txBody>
          <a:bodyPr/>
          <a:lstStyle>
            <a:lvl1pPr marL="0" indent="0">
              <a:buNone/>
              <a:defRPr sz="2260"/>
            </a:lvl1pPr>
            <a:lvl2pPr marL="645658" indent="0">
              <a:buNone/>
              <a:defRPr sz="1977"/>
            </a:lvl2pPr>
            <a:lvl3pPr marL="1291316" indent="0">
              <a:buNone/>
              <a:defRPr sz="1695"/>
            </a:lvl3pPr>
            <a:lvl4pPr marL="1936974" indent="0">
              <a:buNone/>
              <a:defRPr sz="1412"/>
            </a:lvl4pPr>
            <a:lvl5pPr marL="2582631" indent="0">
              <a:buNone/>
              <a:defRPr sz="1412"/>
            </a:lvl5pPr>
            <a:lvl6pPr marL="3228289" indent="0">
              <a:buNone/>
              <a:defRPr sz="1412"/>
            </a:lvl6pPr>
            <a:lvl7pPr marL="3873947" indent="0">
              <a:buNone/>
              <a:defRPr sz="1412"/>
            </a:lvl7pPr>
            <a:lvl8pPr marL="4519605" indent="0">
              <a:buNone/>
              <a:defRPr sz="1412"/>
            </a:lvl8pPr>
            <a:lvl9pPr marL="5165263" indent="0">
              <a:buNone/>
              <a:defRPr sz="14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088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732049"/>
            <a:ext cx="4164690" cy="2562172"/>
          </a:xfrm>
        </p:spPr>
        <p:txBody>
          <a:bodyPr anchor="b"/>
          <a:lstStyle>
            <a:lvl1pPr>
              <a:defRPr sz="45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89590" y="1581025"/>
            <a:ext cx="6537067" cy="7803441"/>
          </a:xfrm>
        </p:spPr>
        <p:txBody>
          <a:bodyPr anchor="t"/>
          <a:lstStyle>
            <a:lvl1pPr marL="0" indent="0">
              <a:buNone/>
              <a:defRPr sz="4519"/>
            </a:lvl1pPr>
            <a:lvl2pPr marL="645658" indent="0">
              <a:buNone/>
              <a:defRPr sz="3954"/>
            </a:lvl2pPr>
            <a:lvl3pPr marL="1291316" indent="0">
              <a:buNone/>
              <a:defRPr sz="3389"/>
            </a:lvl3pPr>
            <a:lvl4pPr marL="1936974" indent="0">
              <a:buNone/>
              <a:defRPr sz="2824"/>
            </a:lvl4pPr>
            <a:lvl5pPr marL="2582631" indent="0">
              <a:buNone/>
              <a:defRPr sz="2824"/>
            </a:lvl5pPr>
            <a:lvl6pPr marL="3228289" indent="0">
              <a:buNone/>
              <a:defRPr sz="2824"/>
            </a:lvl6pPr>
            <a:lvl7pPr marL="3873947" indent="0">
              <a:buNone/>
              <a:defRPr sz="2824"/>
            </a:lvl7pPr>
            <a:lvl8pPr marL="4519605" indent="0">
              <a:buNone/>
              <a:defRPr sz="2824"/>
            </a:lvl8pPr>
            <a:lvl9pPr marL="5165263" indent="0">
              <a:buNone/>
              <a:defRPr sz="282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3294221"/>
            <a:ext cx="4164690" cy="6102953"/>
          </a:xfrm>
        </p:spPr>
        <p:txBody>
          <a:bodyPr/>
          <a:lstStyle>
            <a:lvl1pPr marL="0" indent="0">
              <a:buNone/>
              <a:defRPr sz="2260"/>
            </a:lvl1pPr>
            <a:lvl2pPr marL="645658" indent="0">
              <a:buNone/>
              <a:defRPr sz="1977"/>
            </a:lvl2pPr>
            <a:lvl3pPr marL="1291316" indent="0">
              <a:buNone/>
              <a:defRPr sz="1695"/>
            </a:lvl3pPr>
            <a:lvl4pPr marL="1936974" indent="0">
              <a:buNone/>
              <a:defRPr sz="1412"/>
            </a:lvl4pPr>
            <a:lvl5pPr marL="2582631" indent="0">
              <a:buNone/>
              <a:defRPr sz="1412"/>
            </a:lvl5pPr>
            <a:lvl6pPr marL="3228289" indent="0">
              <a:buNone/>
              <a:defRPr sz="1412"/>
            </a:lvl6pPr>
            <a:lvl7pPr marL="3873947" indent="0">
              <a:buNone/>
              <a:defRPr sz="1412"/>
            </a:lvl7pPr>
            <a:lvl8pPr marL="4519605" indent="0">
              <a:buNone/>
              <a:defRPr sz="1412"/>
            </a:lvl8pPr>
            <a:lvl9pPr marL="5165263" indent="0">
              <a:buNone/>
              <a:defRPr sz="14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138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7750" y="584625"/>
            <a:ext cx="11137225" cy="21224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750" y="2923113"/>
            <a:ext cx="11137225" cy="69671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7750" y="10177520"/>
            <a:ext cx="2905363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77340" y="10177520"/>
            <a:ext cx="4358045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19612" y="10177520"/>
            <a:ext cx="2905363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717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91316" rtl="0" eaLnBrk="1" latinLnBrk="1" hangingPunct="1">
        <a:lnSpc>
          <a:spcPct val="90000"/>
        </a:lnSpc>
        <a:spcBef>
          <a:spcPct val="0"/>
        </a:spcBef>
        <a:buNone/>
        <a:defRPr sz="62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2829" indent="-322829" algn="l" defTabSz="1291316" rtl="0" eaLnBrk="1" latinLnBrk="1" hangingPunct="1">
        <a:lnSpc>
          <a:spcPct val="90000"/>
        </a:lnSpc>
        <a:spcBef>
          <a:spcPts val="1412"/>
        </a:spcBef>
        <a:buFont typeface="Arial" panose="020B0604020202020204" pitchFamily="34" charset="0"/>
        <a:buChar char="•"/>
        <a:defRPr sz="3954" kern="1200">
          <a:solidFill>
            <a:schemeClr val="tx1"/>
          </a:solidFill>
          <a:latin typeface="+mn-lt"/>
          <a:ea typeface="+mn-ea"/>
          <a:cs typeface="+mn-cs"/>
        </a:defRPr>
      </a:lvl1pPr>
      <a:lvl2pPr marL="968487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3389" kern="1200">
          <a:solidFill>
            <a:schemeClr val="tx1"/>
          </a:solidFill>
          <a:latin typeface="+mn-lt"/>
          <a:ea typeface="+mn-ea"/>
          <a:cs typeface="+mn-cs"/>
        </a:defRPr>
      </a:lvl2pPr>
      <a:lvl3pPr marL="1614145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824" kern="1200">
          <a:solidFill>
            <a:schemeClr val="tx1"/>
          </a:solidFill>
          <a:latin typeface="+mn-lt"/>
          <a:ea typeface="+mn-ea"/>
          <a:cs typeface="+mn-cs"/>
        </a:defRPr>
      </a:lvl3pPr>
      <a:lvl4pPr marL="2259802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4pPr>
      <a:lvl5pPr marL="2905460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5pPr>
      <a:lvl6pPr marL="3551118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6pPr>
      <a:lvl7pPr marL="4196776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7pPr>
      <a:lvl8pPr marL="4842434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8pPr>
      <a:lvl9pPr marL="5488092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1pPr>
      <a:lvl2pPr marL="645658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2pPr>
      <a:lvl3pPr marL="1291316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3pPr>
      <a:lvl4pPr marL="1936974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4pPr>
      <a:lvl5pPr marL="2582631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5pPr>
      <a:lvl6pPr marL="3228289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6pPr>
      <a:lvl7pPr marL="3873947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7pPr>
      <a:lvl8pPr marL="4519605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8pPr>
      <a:lvl9pPr marL="5165263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B81BE0E0-E3FF-3DAE-7F79-A610594B98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375" y="2408998"/>
            <a:ext cx="3709761" cy="3201644"/>
          </a:xfrm>
          <a:prstGeom prst="rect">
            <a:avLst/>
          </a:prstGeom>
        </p:spPr>
      </p:pic>
      <p:pic>
        <p:nvPicPr>
          <p:cNvPr id="7" name="그림 6" descr="텍스트, 스크린샷, 라인, 도표이(가) 표시된 사진&#10;&#10;자동 생성된 설명">
            <a:extLst>
              <a:ext uri="{FF2B5EF4-FFF2-40B4-BE49-F238E27FC236}">
                <a16:creationId xmlns:a16="http://schemas.microsoft.com/office/drawing/2014/main" id="{6F183281-212D-39F9-96FF-ECB777A3CF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5619" y="2265894"/>
            <a:ext cx="3884068" cy="3318771"/>
          </a:xfrm>
          <a:prstGeom prst="rect">
            <a:avLst/>
          </a:prstGeom>
        </p:spPr>
      </p:pic>
      <p:pic>
        <p:nvPicPr>
          <p:cNvPr id="25" name="그림 24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EF54184C-9E0D-33DC-1555-0FC7D619B7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0537" y="2408998"/>
            <a:ext cx="3781059" cy="3174430"/>
          </a:xfrm>
          <a:prstGeom prst="rect">
            <a:avLst/>
          </a:prstGeom>
        </p:spPr>
      </p:pic>
      <p:pic>
        <p:nvPicPr>
          <p:cNvPr id="26" name="그림 25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A37C3B6C-559A-93F0-A11E-C9EAC2AC6AD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856" y="7589088"/>
            <a:ext cx="3811831" cy="3174430"/>
          </a:xfrm>
          <a:prstGeom prst="rect">
            <a:avLst/>
          </a:prstGeom>
        </p:spPr>
      </p:pic>
      <p:pic>
        <p:nvPicPr>
          <p:cNvPr id="27" name="그림 26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6212F267-255A-E98F-FD6C-4C350A7A3A4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165" y="7611553"/>
            <a:ext cx="3993461" cy="3174430"/>
          </a:xfrm>
          <a:prstGeom prst="rect">
            <a:avLst/>
          </a:prstGeom>
        </p:spPr>
      </p:pic>
      <p:pic>
        <p:nvPicPr>
          <p:cNvPr id="28" name="그림 27" descr="텍스트, 스크린샷, 도표이(가) 표시된 사진&#10;&#10;자동 생성된 설명">
            <a:extLst>
              <a:ext uri="{FF2B5EF4-FFF2-40B4-BE49-F238E27FC236}">
                <a16:creationId xmlns:a16="http://schemas.microsoft.com/office/drawing/2014/main" id="{38C628ED-07F6-7972-7D58-F38A1AABFEB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199" y="7684959"/>
            <a:ext cx="3979765" cy="310102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549A40D2-B161-41AC-AD42-9BBE11DBEF59}"/>
              </a:ext>
            </a:extLst>
          </p:cNvPr>
          <p:cNvSpPr txBox="1"/>
          <p:nvPr/>
        </p:nvSpPr>
        <p:spPr>
          <a:xfrm>
            <a:off x="802584" y="1015441"/>
            <a:ext cx="3446023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UcParenBoth"/>
            </a:pPr>
            <a:r>
              <a:rPr lang="en-US" altLang="ko-KR" b="1" dirty="0"/>
              <a:t>Agreement between actual </a:t>
            </a:r>
          </a:p>
          <a:p>
            <a:r>
              <a:rPr lang="en-US" altLang="ko-KR" b="1" dirty="0"/>
              <a:t>    and predicted BFM (Total)</a:t>
            </a:r>
          </a:p>
          <a:p>
            <a:pPr algn="ctr"/>
            <a:r>
              <a:rPr lang="en-US" altLang="ko-KR" sz="1400" dirty="0"/>
              <a:t>Mean difference: -0.211</a:t>
            </a:r>
          </a:p>
          <a:p>
            <a:pPr algn="ctr"/>
            <a:r>
              <a:rPr lang="en-US" altLang="ko-KR" sz="1400" dirty="0"/>
              <a:t>95% limits of agreement: -5.521 to  5.098</a:t>
            </a:r>
          </a:p>
          <a:p>
            <a:pPr algn="ctr"/>
            <a:endParaRPr lang="en-US" altLang="ko-KR" sz="1400" dirty="0"/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C2D4290-83CA-546A-268C-60FFDCA6B305}"/>
              </a:ext>
            </a:extLst>
          </p:cNvPr>
          <p:cNvSpPr txBox="1"/>
          <p:nvPr/>
        </p:nvSpPr>
        <p:spPr>
          <a:xfrm>
            <a:off x="4962400" y="998519"/>
            <a:ext cx="34460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B) Agreement between actual </a:t>
            </a:r>
          </a:p>
          <a:p>
            <a:r>
              <a:rPr lang="en-US" altLang="ko-KR" b="1" dirty="0"/>
              <a:t>    and predicted BFM (Men)</a:t>
            </a:r>
          </a:p>
          <a:p>
            <a:pPr algn="ctr"/>
            <a:r>
              <a:rPr lang="en-US" altLang="ko-KR" sz="1400" dirty="0"/>
              <a:t>Mean difference: -1.298</a:t>
            </a:r>
          </a:p>
          <a:p>
            <a:pPr algn="ctr"/>
            <a:r>
              <a:rPr lang="en-US" altLang="ko-KR" sz="1400" dirty="0"/>
              <a:t>95% limits of agreement: --7.516 to 4.938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0309B63-1CFE-2EFE-B9B5-8D7A365C6ACC}"/>
              </a:ext>
            </a:extLst>
          </p:cNvPr>
          <p:cNvSpPr txBox="1"/>
          <p:nvPr/>
        </p:nvSpPr>
        <p:spPr>
          <a:xfrm>
            <a:off x="8759907" y="999757"/>
            <a:ext cx="36100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   (C) Agreement between actual </a:t>
            </a:r>
          </a:p>
          <a:p>
            <a:r>
              <a:rPr lang="en-US" altLang="ko-KR" b="1" dirty="0"/>
              <a:t>      and predicted BFM (Women)</a:t>
            </a:r>
          </a:p>
          <a:p>
            <a:pPr algn="ctr"/>
            <a:r>
              <a:rPr lang="en-US" altLang="ko-KR" sz="1400" dirty="0"/>
              <a:t>Mean difference: -0.688</a:t>
            </a:r>
          </a:p>
          <a:p>
            <a:pPr algn="ctr"/>
            <a:r>
              <a:rPr lang="en-US" altLang="ko-KR" sz="1400" dirty="0"/>
              <a:t>95% limits of agreement: -6.823 to 5.451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58350B1-BEF6-2452-8208-F4A3A8ED5EA4}"/>
              </a:ext>
            </a:extLst>
          </p:cNvPr>
          <p:cNvSpPr txBox="1"/>
          <p:nvPr/>
        </p:nvSpPr>
        <p:spPr>
          <a:xfrm>
            <a:off x="802583" y="6092746"/>
            <a:ext cx="3446023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D)</a:t>
            </a:r>
            <a:r>
              <a:rPr lang="ko-KR" altLang="en-US" b="1" dirty="0"/>
              <a:t> </a:t>
            </a:r>
            <a:r>
              <a:rPr lang="en-US" altLang="ko-KR" b="1" dirty="0"/>
              <a:t>Agreement between actual </a:t>
            </a:r>
          </a:p>
          <a:p>
            <a:r>
              <a:rPr lang="en-US" altLang="ko-KR" b="1" dirty="0"/>
              <a:t>    and predicted LBM (Total)</a:t>
            </a:r>
          </a:p>
          <a:p>
            <a:pPr algn="ctr"/>
            <a:r>
              <a:rPr lang="en-US" altLang="ko-KR" sz="1400" dirty="0"/>
              <a:t>Mean difference: 0.290</a:t>
            </a:r>
          </a:p>
          <a:p>
            <a:pPr algn="ctr"/>
            <a:r>
              <a:rPr lang="en-US" altLang="ko-KR" sz="1400" dirty="0"/>
              <a:t>95% limits of agreement: -5.254 to 5.583 </a:t>
            </a:r>
          </a:p>
          <a:p>
            <a:pPr algn="ctr"/>
            <a:endParaRPr lang="ko-KR" altLang="en-US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F566DC3-DBE2-50A7-D072-B6DF87688FC9}"/>
              </a:ext>
            </a:extLst>
          </p:cNvPr>
          <p:cNvSpPr txBox="1"/>
          <p:nvPr/>
        </p:nvSpPr>
        <p:spPr>
          <a:xfrm>
            <a:off x="4849780" y="6115299"/>
            <a:ext cx="34460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E) Agreement between actual </a:t>
            </a:r>
          </a:p>
          <a:p>
            <a:r>
              <a:rPr lang="en-US" altLang="ko-KR" b="1" dirty="0"/>
              <a:t>    and predicted LBM (Men)</a:t>
            </a:r>
          </a:p>
          <a:p>
            <a:pPr algn="ctr"/>
            <a:r>
              <a:rPr lang="en-US" altLang="ko-KR" sz="1400" dirty="0"/>
              <a:t>Mean difference: 1.262</a:t>
            </a:r>
          </a:p>
          <a:p>
            <a:pPr algn="ctr"/>
            <a:r>
              <a:rPr lang="en-US" altLang="ko-KR" sz="1400" dirty="0"/>
              <a:t>95% limits of agreement: -5.233 to 7.759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D8DAF6A-D9D3-46E5-D0A4-12BAAAF7245E}"/>
              </a:ext>
            </a:extLst>
          </p:cNvPr>
          <p:cNvSpPr txBox="1"/>
          <p:nvPr/>
        </p:nvSpPr>
        <p:spPr>
          <a:xfrm>
            <a:off x="8665619" y="6156145"/>
            <a:ext cx="36100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     (F) Agreement between actual </a:t>
            </a:r>
          </a:p>
          <a:p>
            <a:r>
              <a:rPr lang="en-US" altLang="ko-KR" b="1" dirty="0"/>
              <a:t>       and predicted LBM (Women)</a:t>
            </a:r>
          </a:p>
          <a:p>
            <a:pPr algn="ctr"/>
            <a:r>
              <a:rPr lang="en-US" altLang="ko-KR" sz="1400" dirty="0"/>
              <a:t>Mean difference: -0.299</a:t>
            </a:r>
          </a:p>
          <a:p>
            <a:pPr algn="ctr"/>
            <a:r>
              <a:rPr lang="en-US" altLang="ko-KR" sz="1400" dirty="0"/>
              <a:t>95% limits of agreement: -5.081 to 4.481 </a:t>
            </a:r>
          </a:p>
          <a:p>
            <a:pPr algn="ctr"/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3CC9AA-26FA-3AD2-5616-B24CBD74D53A}"/>
              </a:ext>
            </a:extLst>
          </p:cNvPr>
          <p:cNvSpPr txBox="1"/>
          <p:nvPr/>
        </p:nvSpPr>
        <p:spPr>
          <a:xfrm rot="16200000">
            <a:off x="-850364" y="3305489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 - Predicted BFM)</a:t>
            </a:r>
            <a:endParaRPr lang="ko-KR" alt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80E1B1C-5782-65BA-EB03-E4005B456A6F}"/>
              </a:ext>
            </a:extLst>
          </p:cNvPr>
          <p:cNvSpPr txBox="1"/>
          <p:nvPr/>
        </p:nvSpPr>
        <p:spPr>
          <a:xfrm rot="16200000">
            <a:off x="3179856" y="3305489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TFM - Predicted TFM)</a:t>
            </a:r>
            <a:endParaRPr lang="ko-KR" altLang="en-US" sz="11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C6B68EC-F57B-C1A5-8B87-27D3DE0EA4F8}"/>
              </a:ext>
            </a:extLst>
          </p:cNvPr>
          <p:cNvSpPr txBox="1"/>
          <p:nvPr/>
        </p:nvSpPr>
        <p:spPr>
          <a:xfrm rot="16200000">
            <a:off x="7106960" y="3291631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TFM - Predicted TFM)</a:t>
            </a:r>
            <a:endParaRPr lang="ko-KR" altLang="en-US" sz="11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7AA216-DF50-0D66-EF32-BD54A8AA60B5}"/>
              </a:ext>
            </a:extLst>
          </p:cNvPr>
          <p:cNvSpPr txBox="1"/>
          <p:nvPr/>
        </p:nvSpPr>
        <p:spPr>
          <a:xfrm>
            <a:off x="890799" y="5459451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7DD32AB-1146-40EB-3909-3D199FAB0E30}"/>
              </a:ext>
            </a:extLst>
          </p:cNvPr>
          <p:cNvSpPr txBox="1"/>
          <p:nvPr/>
        </p:nvSpPr>
        <p:spPr>
          <a:xfrm rot="16200000">
            <a:off x="3163470" y="3318226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- Predicted BFM)</a:t>
            </a:r>
            <a:endParaRPr lang="ko-KR" altLang="en-US" sz="11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EFB512-D4E6-2BFA-E7B7-A4AF376B498D}"/>
              </a:ext>
            </a:extLst>
          </p:cNvPr>
          <p:cNvSpPr txBox="1"/>
          <p:nvPr/>
        </p:nvSpPr>
        <p:spPr>
          <a:xfrm>
            <a:off x="4849778" y="5453277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9BFFAB-13B8-AF42-8201-87FBFDA58E42}"/>
              </a:ext>
            </a:extLst>
          </p:cNvPr>
          <p:cNvSpPr txBox="1"/>
          <p:nvPr/>
        </p:nvSpPr>
        <p:spPr>
          <a:xfrm rot="16200000">
            <a:off x="7124363" y="3291631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 - Predicted BFM)</a:t>
            </a:r>
            <a:endParaRPr lang="ko-KR" altLang="en-US" sz="11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71E572-B0C6-999F-59C2-61AD127B40F1}"/>
              </a:ext>
            </a:extLst>
          </p:cNvPr>
          <p:cNvSpPr txBox="1"/>
          <p:nvPr/>
        </p:nvSpPr>
        <p:spPr>
          <a:xfrm>
            <a:off x="8835870" y="5425092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2C9E58-ED44-A228-42DE-08C68783B30B}"/>
              </a:ext>
            </a:extLst>
          </p:cNvPr>
          <p:cNvSpPr txBox="1"/>
          <p:nvPr/>
        </p:nvSpPr>
        <p:spPr>
          <a:xfrm rot="16200000">
            <a:off x="-1089375" y="8779694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- Predicted LBM)</a:t>
            </a:r>
            <a:endParaRPr lang="ko-KR" altLang="en-US" sz="11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15F86F-7F57-9521-2997-8B0366BA61C1}"/>
              </a:ext>
            </a:extLst>
          </p:cNvPr>
          <p:cNvSpPr txBox="1"/>
          <p:nvPr/>
        </p:nvSpPr>
        <p:spPr>
          <a:xfrm>
            <a:off x="723519" y="10635752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7B121F-3BEF-3CE1-756F-B8BCEA464733}"/>
              </a:ext>
            </a:extLst>
          </p:cNvPr>
          <p:cNvSpPr txBox="1"/>
          <p:nvPr/>
        </p:nvSpPr>
        <p:spPr>
          <a:xfrm rot="16200000">
            <a:off x="3066028" y="8742380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 - Predicted LBM)</a:t>
            </a:r>
            <a:endParaRPr lang="ko-KR" altLang="en-US" sz="11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9EFB19-09EC-89F1-A1C2-F48AD3F1B295}"/>
              </a:ext>
            </a:extLst>
          </p:cNvPr>
          <p:cNvSpPr txBox="1"/>
          <p:nvPr/>
        </p:nvSpPr>
        <p:spPr>
          <a:xfrm>
            <a:off x="4849778" y="10631303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2B25AC5-F550-547A-7C3C-5CC42318BBBC}"/>
              </a:ext>
            </a:extLst>
          </p:cNvPr>
          <p:cNvSpPr txBox="1"/>
          <p:nvPr/>
        </p:nvSpPr>
        <p:spPr>
          <a:xfrm rot="16200000">
            <a:off x="7168842" y="8777053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 - Predicted LBM)</a:t>
            </a:r>
            <a:endParaRPr lang="ko-KR" altLang="en-US" sz="11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8EBE54-0362-C1B9-13EE-13306B3E6B30}"/>
              </a:ext>
            </a:extLst>
          </p:cNvPr>
          <p:cNvSpPr txBox="1"/>
          <p:nvPr/>
        </p:nvSpPr>
        <p:spPr>
          <a:xfrm>
            <a:off x="8908113" y="10631303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38CFEB1-5D97-15BA-1BB8-A579D9511F5B}"/>
              </a:ext>
            </a:extLst>
          </p:cNvPr>
          <p:cNvSpPr txBox="1"/>
          <p:nvPr/>
        </p:nvSpPr>
        <p:spPr>
          <a:xfrm>
            <a:off x="-4907" y="43317"/>
            <a:ext cx="129562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/>
              <a:t>Supplementary </a:t>
            </a:r>
            <a:r>
              <a:rPr lang="en-US" altLang="ko-KR" b="1" dirty="0"/>
              <a:t>Figure 5. </a:t>
            </a:r>
            <a:r>
              <a:rPr lang="en-US" altLang="ko-KR" dirty="0"/>
              <a:t>Bland-Altman plots for evaluating differences in actual and predicted values of body</a:t>
            </a:r>
            <a:r>
              <a:rPr lang="ko-KR" altLang="en-US" dirty="0"/>
              <a:t> </a:t>
            </a:r>
            <a:r>
              <a:rPr lang="en-US" altLang="ko-KR" dirty="0"/>
              <a:t>fat</a:t>
            </a:r>
            <a:r>
              <a:rPr lang="ko-KR" altLang="en-US" dirty="0"/>
              <a:t> </a:t>
            </a:r>
            <a:r>
              <a:rPr lang="en-US" altLang="ko-KR" dirty="0"/>
              <a:t>mass</a:t>
            </a:r>
            <a:r>
              <a:rPr lang="ko-KR" altLang="en-US" dirty="0"/>
              <a:t> </a:t>
            </a:r>
            <a:r>
              <a:rPr lang="en-US" altLang="ko-KR" dirty="0"/>
              <a:t>(BFM) and lean body mass (LBM) in adult cancer survivors without obesity (body mass index</a:t>
            </a:r>
            <a:r>
              <a:rPr lang="en-US" altLang="ko-KR" dirty="0">
                <a:latin typeface="맑은 고딕" panose="020B0503020000020004" pitchFamily="50" charset="-127"/>
                <a:ea typeface="맑은 고딕" panose="020B0503020000020004" pitchFamily="50" charset="-127"/>
              </a:rPr>
              <a:t>&lt;</a:t>
            </a:r>
            <a:r>
              <a:rPr lang="en-US" altLang="ko-KR" dirty="0"/>
              <a:t>25.0 kg/m</a:t>
            </a:r>
            <a:r>
              <a:rPr lang="en-US" altLang="ko-KR" baseline="30000" dirty="0"/>
              <a:t>2</a:t>
            </a:r>
            <a:r>
              <a:rPr lang="en-US" altLang="ko-KR" dirty="0"/>
              <a:t>)in the Korean National Health and Nutrition Examination Survey (2008-2011) 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648833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1</TotalTime>
  <Words>342</Words>
  <Application>Microsoft Office PowerPoint</Application>
  <PresentationFormat>사용자 지정</PresentationFormat>
  <Paragraphs>4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국립암센터 호스피스완화의료사업과</dc:creator>
  <cp:lastModifiedBy>NCC</cp:lastModifiedBy>
  <cp:revision>6</cp:revision>
  <dcterms:created xsi:type="dcterms:W3CDTF">2023-07-03T23:34:17Z</dcterms:created>
  <dcterms:modified xsi:type="dcterms:W3CDTF">2023-12-27T04:49:52Z</dcterms:modified>
</cp:coreProperties>
</file>